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C7A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27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2_1">
  <dgm:title val=""/>
  <dgm:desc val=""/>
  <dgm:catLst>
    <dgm:cat type="accent2" pri="11100"/>
  </dgm:catLst>
  <dgm:styleLbl name="node0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2">
        <a:tint val="40000"/>
      </a:schemeClr>
    </dgm:fillClrLst>
    <dgm:linClrLst meth="repeat">
      <a:schemeClr val="accent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2">
        <a:tint val="40000"/>
      </a:schemeClr>
    </dgm:fillClrLst>
    <dgm:linClrLst meth="repeat">
      <a:schemeClr val="accent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2">
        <a:tint val="40000"/>
      </a:schemeClr>
    </dgm:fillClrLst>
    <dgm:linClrLst meth="repeat">
      <a:schemeClr val="accent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2"/>
    </dgm:fillClrLst>
    <dgm:linClrLst meth="repeat">
      <a:schemeClr val="accent2"/>
    </dgm:linClrLst>
    <dgm:effectClrLst/>
    <dgm:txLinClrLst/>
    <dgm:txFillClrLst/>
    <dgm:txEffectClrLst/>
  </dgm:styleLbl>
  <dgm:styleLbl name="parChTrans2D3">
    <dgm:fillClrLst meth="repeat">
      <a:schemeClr val="accent2"/>
    </dgm:fillClrLst>
    <dgm:linClrLst meth="repeat">
      <a:schemeClr val="accent2"/>
    </dgm:linClrLst>
    <dgm:effectClrLst/>
    <dgm:txLinClrLst/>
    <dgm:txFillClrLst/>
    <dgm:txEffectClrLst/>
  </dgm:styleLbl>
  <dgm:styleLbl name="parChTrans2D4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/>
    </dgm:fillClrLst>
    <dgm:linClrLst meth="repeat">
      <a:schemeClr val="accent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/>
    </dgm:fillClrLst>
    <dgm:linClrLst meth="repeat">
      <a:schemeClr val="accent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/>
    </dgm:fillClrLst>
    <dgm:linClrLst meth="repeat">
      <a:schemeClr val="accent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2">
        <a:alpha val="4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2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2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2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8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77D6CE3-9C2F-4272-BA94-CFD6D1D0BF22}" type="doc">
      <dgm:prSet loTypeId="urn:microsoft.com/office/officeart/2005/8/layout/process3" loCatId="process" qsTypeId="urn:microsoft.com/office/officeart/2005/8/quickstyle/simple1" qsCatId="simple" csTypeId="urn:microsoft.com/office/officeart/2005/8/colors/accent2_1" csCatId="accent2" phldr="1"/>
      <dgm:spPr/>
      <dgm:t>
        <a:bodyPr/>
        <a:lstStyle/>
        <a:p>
          <a:endParaRPr lang="en-US"/>
        </a:p>
      </dgm:t>
    </dgm:pt>
    <dgm:pt modelId="{B084E76E-5D59-47F6-AA35-C2AC3CE6E48D}">
      <dgm:prSet phldrT="[Text]" custT="1"/>
      <dgm:spPr/>
      <dgm:t>
        <a:bodyPr/>
        <a:lstStyle/>
        <a:p>
          <a:r>
            <a:rPr lang="en-US" sz="1400" dirty="0" err="1" smtClean="0"/>
            <a:t>BCraw</a:t>
          </a:r>
          <a:endParaRPr lang="en-US" sz="1400" dirty="0"/>
        </a:p>
      </dgm:t>
    </dgm:pt>
    <dgm:pt modelId="{D44DC417-2815-4150-BD33-A6B5F3E4EF90}" type="parTrans" cxnId="{045F558A-B2A3-4689-8B3A-2125E38AF91B}">
      <dgm:prSet/>
      <dgm:spPr/>
      <dgm:t>
        <a:bodyPr/>
        <a:lstStyle/>
        <a:p>
          <a:endParaRPr lang="en-US" sz="3600"/>
        </a:p>
      </dgm:t>
    </dgm:pt>
    <dgm:pt modelId="{8B3EAF7A-687C-47F4-A21D-9B7C76DDD00C}" type="sibTrans" cxnId="{045F558A-B2A3-4689-8B3A-2125E38AF91B}">
      <dgm:prSet custT="1"/>
      <dgm:spPr/>
      <dgm:t>
        <a:bodyPr/>
        <a:lstStyle/>
        <a:p>
          <a:endParaRPr lang="en-US" sz="1100"/>
        </a:p>
      </dgm:t>
    </dgm:pt>
    <dgm:pt modelId="{865FB31D-F3EA-4B0C-944A-3C4DDE361870}">
      <dgm:prSet phldrT="[Text]" custT="1"/>
      <dgm:spPr/>
      <dgm:t>
        <a:bodyPr/>
        <a:lstStyle/>
        <a:p>
          <a:r>
            <a:rPr lang="en-US" sz="1200" dirty="0" smtClean="0"/>
            <a:t>Barcode-split individual sample sequence files (Sample.1.fq, Sample.2.fq) </a:t>
          </a:r>
          <a:endParaRPr lang="en-US" sz="1200" dirty="0"/>
        </a:p>
      </dgm:t>
    </dgm:pt>
    <dgm:pt modelId="{B791EE00-3CA1-49FC-B331-CAF8A29C5562}" type="parTrans" cxnId="{CDEE0858-74A7-42F3-BD51-16F36E979F5A}">
      <dgm:prSet/>
      <dgm:spPr/>
      <dgm:t>
        <a:bodyPr/>
        <a:lstStyle/>
        <a:p>
          <a:endParaRPr lang="en-US" sz="3600"/>
        </a:p>
      </dgm:t>
    </dgm:pt>
    <dgm:pt modelId="{E7339645-DB51-401C-AF13-946FDF0EAF09}" type="sibTrans" cxnId="{CDEE0858-74A7-42F3-BD51-16F36E979F5A}">
      <dgm:prSet/>
      <dgm:spPr/>
      <dgm:t>
        <a:bodyPr/>
        <a:lstStyle/>
        <a:p>
          <a:endParaRPr lang="en-US" sz="3600"/>
        </a:p>
      </dgm:t>
    </dgm:pt>
    <dgm:pt modelId="{0A65F02B-27B3-4A9B-96CA-70BF9D829387}">
      <dgm:prSet phldrT="[Text]" custT="1"/>
      <dgm:spPr/>
      <dgm:t>
        <a:bodyPr/>
        <a:lstStyle/>
        <a:p>
          <a:r>
            <a:rPr lang="en-US" sz="1400" dirty="0" err="1" smtClean="0"/>
            <a:t>BCpc</a:t>
          </a:r>
          <a:endParaRPr lang="en-US" sz="1400" dirty="0"/>
        </a:p>
      </dgm:t>
    </dgm:pt>
    <dgm:pt modelId="{072DFE95-F855-4FDF-89BB-EFAE505818A0}" type="parTrans" cxnId="{BE28DBBC-76D0-4B90-8534-B8A7DAA29042}">
      <dgm:prSet/>
      <dgm:spPr/>
      <dgm:t>
        <a:bodyPr/>
        <a:lstStyle/>
        <a:p>
          <a:endParaRPr lang="en-US" sz="3600"/>
        </a:p>
      </dgm:t>
    </dgm:pt>
    <dgm:pt modelId="{BD53C65D-FB47-4739-B31D-6165D0FD9540}" type="sibTrans" cxnId="{BE28DBBC-76D0-4B90-8534-B8A7DAA29042}">
      <dgm:prSet custT="1"/>
      <dgm:spPr/>
      <dgm:t>
        <a:bodyPr/>
        <a:lstStyle/>
        <a:p>
          <a:endParaRPr lang="en-US" sz="1100"/>
        </a:p>
      </dgm:t>
    </dgm:pt>
    <dgm:pt modelId="{4DC91522-BD99-4926-98E2-E9BB7CB6B06B}">
      <dgm:prSet phldrT="[Text]" custT="1"/>
      <dgm:spPr/>
      <dgm:t>
        <a:bodyPr/>
        <a:lstStyle/>
        <a:p>
          <a:r>
            <a:rPr lang="en-US" sz="1200" dirty="0" smtClean="0"/>
            <a:t>Trimmed sequence files (Sample.1.fq, Sample.2.fq)</a:t>
          </a:r>
          <a:endParaRPr lang="en-US" sz="1200" dirty="0"/>
        </a:p>
      </dgm:t>
    </dgm:pt>
    <dgm:pt modelId="{3766D76B-2DEE-40D6-AAFA-9B8636C715A5}" type="parTrans" cxnId="{A412FBB6-EEAD-49AB-84E5-05245F02D0C2}">
      <dgm:prSet/>
      <dgm:spPr/>
      <dgm:t>
        <a:bodyPr/>
        <a:lstStyle/>
        <a:p>
          <a:endParaRPr lang="en-US" sz="3600"/>
        </a:p>
      </dgm:t>
    </dgm:pt>
    <dgm:pt modelId="{810FE2D9-FFFB-43BF-8477-DCA4A6C13755}" type="sibTrans" cxnId="{A412FBB6-EEAD-49AB-84E5-05245F02D0C2}">
      <dgm:prSet/>
      <dgm:spPr/>
      <dgm:t>
        <a:bodyPr/>
        <a:lstStyle/>
        <a:p>
          <a:endParaRPr lang="en-US" sz="3600"/>
        </a:p>
      </dgm:t>
    </dgm:pt>
    <dgm:pt modelId="{1FBB9CCE-20BC-48D2-B0F4-DEB9678A127E}">
      <dgm:prSet phldrT="[Text]" custT="1"/>
      <dgm:spPr/>
      <dgm:t>
        <a:bodyPr/>
        <a:lstStyle/>
        <a:p>
          <a:r>
            <a:rPr lang="en-US" sz="1400" dirty="0" err="1" smtClean="0"/>
            <a:t>BCfin</a:t>
          </a:r>
          <a:endParaRPr lang="en-US" sz="1400" dirty="0"/>
        </a:p>
      </dgm:t>
    </dgm:pt>
    <dgm:pt modelId="{515EDF0C-EE15-4E6F-9947-5F03BB9C268A}" type="parTrans" cxnId="{416F468E-CECB-4859-B5F0-8F444C7E88EF}">
      <dgm:prSet/>
      <dgm:spPr/>
      <dgm:t>
        <a:bodyPr/>
        <a:lstStyle/>
        <a:p>
          <a:endParaRPr lang="en-US" sz="3600"/>
        </a:p>
      </dgm:t>
    </dgm:pt>
    <dgm:pt modelId="{B4EB7300-A9C9-409C-AA00-35284BA4A7D7}" type="sibTrans" cxnId="{416F468E-CECB-4859-B5F0-8F444C7E88EF}">
      <dgm:prSet custT="1"/>
      <dgm:spPr/>
      <dgm:t>
        <a:bodyPr/>
        <a:lstStyle/>
        <a:p>
          <a:endParaRPr lang="en-US" sz="1100"/>
        </a:p>
      </dgm:t>
    </dgm:pt>
    <dgm:pt modelId="{BB591EEA-1176-4B1E-AA16-4DF85DE1EEB5}">
      <dgm:prSet phldrT="[Text]" custT="1"/>
      <dgm:spPr/>
      <dgm:t>
        <a:bodyPr/>
        <a:lstStyle/>
        <a:p>
          <a:r>
            <a:rPr lang="en-US" sz="1200" dirty="0" smtClean="0"/>
            <a:t>Equal-length sequence files (</a:t>
          </a:r>
          <a:r>
            <a:rPr lang="en-US" sz="1200" dirty="0" err="1" smtClean="0"/>
            <a:t>Sample.fq</a:t>
          </a:r>
          <a:r>
            <a:rPr lang="en-US" sz="1200" dirty="0" smtClean="0"/>
            <a:t>)</a:t>
          </a:r>
          <a:endParaRPr lang="en-US" sz="1200" dirty="0"/>
        </a:p>
      </dgm:t>
    </dgm:pt>
    <dgm:pt modelId="{544FD8B5-6973-4AE9-949C-3319F4B8F7EB}" type="parTrans" cxnId="{11D2A740-034C-4059-BD3C-FD7AA972F0F9}">
      <dgm:prSet/>
      <dgm:spPr/>
      <dgm:t>
        <a:bodyPr/>
        <a:lstStyle/>
        <a:p>
          <a:endParaRPr lang="en-US" sz="3600"/>
        </a:p>
      </dgm:t>
    </dgm:pt>
    <dgm:pt modelId="{317D6593-6D95-49B4-918D-AF6D0C0DE3B4}" type="sibTrans" cxnId="{11D2A740-034C-4059-BD3C-FD7AA972F0F9}">
      <dgm:prSet/>
      <dgm:spPr/>
      <dgm:t>
        <a:bodyPr/>
        <a:lstStyle/>
        <a:p>
          <a:endParaRPr lang="en-US" sz="3600"/>
        </a:p>
      </dgm:t>
    </dgm:pt>
    <dgm:pt modelId="{4BDC33C0-A38F-41C4-A903-2D64017A6869}">
      <dgm:prSet custT="1"/>
      <dgm:spPr/>
      <dgm:t>
        <a:bodyPr/>
        <a:lstStyle/>
        <a:p>
          <a:r>
            <a:rPr lang="en-US" sz="1400" dirty="0" smtClean="0"/>
            <a:t>ASU</a:t>
          </a:r>
          <a:endParaRPr lang="en-US" sz="1400" dirty="0"/>
        </a:p>
      </dgm:t>
    </dgm:pt>
    <dgm:pt modelId="{BAC386CD-22D4-4990-9F36-B6618FF60F75}" type="parTrans" cxnId="{E1E25417-DAAB-4F02-BF9B-E19BBC8F8408}">
      <dgm:prSet/>
      <dgm:spPr/>
      <dgm:t>
        <a:bodyPr/>
        <a:lstStyle/>
        <a:p>
          <a:endParaRPr lang="en-US" sz="3600"/>
        </a:p>
      </dgm:t>
    </dgm:pt>
    <dgm:pt modelId="{83D9FD8C-D811-4DE7-9E07-0B3F9E365BBA}" type="sibTrans" cxnId="{E1E25417-DAAB-4F02-BF9B-E19BBC8F8408}">
      <dgm:prSet custT="1"/>
      <dgm:spPr/>
      <dgm:t>
        <a:bodyPr/>
        <a:lstStyle/>
        <a:p>
          <a:endParaRPr lang="en-US" sz="1100"/>
        </a:p>
      </dgm:t>
    </dgm:pt>
    <dgm:pt modelId="{39ED8232-6914-426A-B41F-D31C3C5C1572}">
      <dgm:prSet custT="1"/>
      <dgm:spPr/>
      <dgm:t>
        <a:bodyPr/>
        <a:lstStyle/>
        <a:p>
          <a:r>
            <a:rPr lang="en-US" sz="1400" dirty="0" smtClean="0"/>
            <a:t>SNP</a:t>
          </a:r>
          <a:endParaRPr lang="en-US" sz="1400" dirty="0"/>
        </a:p>
      </dgm:t>
    </dgm:pt>
    <dgm:pt modelId="{80DB2170-397D-452E-862F-1F51F3E52D27}" type="parTrans" cxnId="{2881B8B0-DDFF-40AE-BCF7-AAE0654A94E2}">
      <dgm:prSet/>
      <dgm:spPr/>
      <dgm:t>
        <a:bodyPr/>
        <a:lstStyle/>
        <a:p>
          <a:endParaRPr lang="en-US" sz="3600"/>
        </a:p>
      </dgm:t>
    </dgm:pt>
    <dgm:pt modelId="{F6D5CB65-2408-4A7E-99FB-4229EE8081B1}" type="sibTrans" cxnId="{2881B8B0-DDFF-40AE-BCF7-AAE0654A94E2}">
      <dgm:prSet/>
      <dgm:spPr/>
      <dgm:t>
        <a:bodyPr/>
        <a:lstStyle/>
        <a:p>
          <a:endParaRPr lang="en-US" sz="3600"/>
        </a:p>
      </dgm:t>
    </dgm:pt>
    <dgm:pt modelId="{D71AF31F-0E14-4E3D-899F-9CFADD8ACB8E}">
      <dgm:prSet custT="1"/>
      <dgm:spPr/>
      <dgm:t>
        <a:bodyPr/>
        <a:lstStyle/>
        <a:p>
          <a:r>
            <a:rPr lang="en-US" sz="1200" dirty="0" smtClean="0"/>
            <a:t>ASU files for each sample (</a:t>
          </a:r>
          <a:r>
            <a:rPr lang="en-US" sz="1200" dirty="0" err="1" smtClean="0"/>
            <a:t>Sample.tags.tsv</a:t>
          </a:r>
          <a:r>
            <a:rPr lang="en-US" sz="1200" dirty="0" smtClean="0"/>
            <a:t>)</a:t>
          </a:r>
          <a:endParaRPr lang="en-US" sz="1200" dirty="0"/>
        </a:p>
      </dgm:t>
    </dgm:pt>
    <dgm:pt modelId="{B042C0C1-B933-4206-9B29-51FC9100CBB9}" type="parTrans" cxnId="{5C8B003F-5C26-483E-A4C4-A38B6CD729E9}">
      <dgm:prSet/>
      <dgm:spPr/>
      <dgm:t>
        <a:bodyPr/>
        <a:lstStyle/>
        <a:p>
          <a:endParaRPr lang="en-US" sz="3600"/>
        </a:p>
      </dgm:t>
    </dgm:pt>
    <dgm:pt modelId="{DC4E7D7F-AACE-4874-8D47-4C5830753530}" type="sibTrans" cxnId="{5C8B003F-5C26-483E-A4C4-A38B6CD729E9}">
      <dgm:prSet/>
      <dgm:spPr/>
      <dgm:t>
        <a:bodyPr/>
        <a:lstStyle/>
        <a:p>
          <a:endParaRPr lang="en-US" sz="3600"/>
        </a:p>
      </dgm:t>
    </dgm:pt>
    <dgm:pt modelId="{B93D8440-7DBC-4A03-BE58-22D44C980A52}">
      <dgm:prSet custT="1"/>
      <dgm:spPr/>
      <dgm:t>
        <a:bodyPr/>
        <a:lstStyle/>
        <a:p>
          <a:r>
            <a:rPr lang="en-US" sz="1200" dirty="0" smtClean="0"/>
            <a:t>Alignment data and SNP calling (</a:t>
          </a:r>
          <a:r>
            <a:rPr lang="en-US" sz="1200" dirty="0" err="1" smtClean="0"/>
            <a:t>Sample.Gr.sorted.bam</a:t>
          </a:r>
          <a:r>
            <a:rPr lang="en-US" sz="1200" dirty="0" smtClean="0"/>
            <a:t>)</a:t>
          </a:r>
          <a:endParaRPr lang="en-US" sz="1200" dirty="0"/>
        </a:p>
      </dgm:t>
    </dgm:pt>
    <dgm:pt modelId="{7ECBB7E3-CBFB-42CF-A25F-EB8C17C5F9D1}" type="parTrans" cxnId="{6B6C0A2F-56E6-49B1-8797-4A72BB7C0CE8}">
      <dgm:prSet/>
      <dgm:spPr/>
      <dgm:t>
        <a:bodyPr/>
        <a:lstStyle/>
        <a:p>
          <a:endParaRPr lang="en-US" sz="3600"/>
        </a:p>
      </dgm:t>
    </dgm:pt>
    <dgm:pt modelId="{17576FED-3B7E-4F57-873D-AE297F002AED}" type="sibTrans" cxnId="{6B6C0A2F-56E6-49B1-8797-4A72BB7C0CE8}">
      <dgm:prSet/>
      <dgm:spPr/>
      <dgm:t>
        <a:bodyPr/>
        <a:lstStyle/>
        <a:p>
          <a:endParaRPr lang="en-US" sz="3600"/>
        </a:p>
      </dgm:t>
    </dgm:pt>
    <dgm:pt modelId="{A950816C-6FDB-49C1-BC18-B3A22682E177}">
      <dgm:prSet custT="1"/>
      <dgm:spPr/>
      <dgm:t>
        <a:bodyPr/>
        <a:lstStyle/>
        <a:p>
          <a:r>
            <a:rPr lang="en-US" sz="1400" dirty="0" smtClean="0"/>
            <a:t>Ref</a:t>
          </a:r>
          <a:endParaRPr lang="en-US" sz="1400" dirty="0"/>
        </a:p>
      </dgm:t>
    </dgm:pt>
    <dgm:pt modelId="{CA710D8C-7087-4B7F-81C1-E632808A93BF}" type="parTrans" cxnId="{976710D4-1F34-461D-A3E1-FA3647CBBB51}">
      <dgm:prSet/>
      <dgm:spPr/>
      <dgm:t>
        <a:bodyPr/>
        <a:lstStyle/>
        <a:p>
          <a:endParaRPr lang="en-US"/>
        </a:p>
      </dgm:t>
    </dgm:pt>
    <dgm:pt modelId="{669EA603-7D23-4134-AE75-7E5E129C9E8F}" type="sibTrans" cxnId="{976710D4-1F34-461D-A3E1-FA3647CBBB51}">
      <dgm:prSet/>
      <dgm:spPr/>
      <dgm:t>
        <a:bodyPr/>
        <a:lstStyle/>
        <a:p>
          <a:endParaRPr lang="en-US"/>
        </a:p>
      </dgm:t>
    </dgm:pt>
    <dgm:pt modelId="{A52D4BAF-4EEB-45AD-A999-48FDF9E50EF0}">
      <dgm:prSet custT="1"/>
      <dgm:spPr/>
      <dgm:t>
        <a:bodyPr/>
        <a:lstStyle/>
        <a:p>
          <a:r>
            <a:rPr lang="en-US" sz="1200" dirty="0" smtClean="0"/>
            <a:t>Generate reference across all samples (</a:t>
          </a:r>
          <a:r>
            <a:rPr lang="en-US" sz="1200" dirty="0" err="1" smtClean="0"/>
            <a:t>ref.fa</a:t>
          </a:r>
          <a:r>
            <a:rPr lang="en-US" sz="1200" dirty="0" smtClean="0"/>
            <a:t>, ref_98.fa)</a:t>
          </a:r>
          <a:endParaRPr lang="en-US" sz="1200" dirty="0"/>
        </a:p>
      </dgm:t>
    </dgm:pt>
    <dgm:pt modelId="{12B01FCB-9A10-438C-BC20-5F8C9BEE0A55}" type="parTrans" cxnId="{70CA65F2-6292-47CD-9E27-F657DACB1168}">
      <dgm:prSet/>
      <dgm:spPr/>
      <dgm:t>
        <a:bodyPr/>
        <a:lstStyle/>
        <a:p>
          <a:endParaRPr lang="en-US"/>
        </a:p>
      </dgm:t>
    </dgm:pt>
    <dgm:pt modelId="{9289D44E-17AA-460F-9025-F0944057AC28}" type="sibTrans" cxnId="{70CA65F2-6292-47CD-9E27-F657DACB1168}">
      <dgm:prSet/>
      <dgm:spPr/>
      <dgm:t>
        <a:bodyPr/>
        <a:lstStyle/>
        <a:p>
          <a:endParaRPr lang="en-US"/>
        </a:p>
      </dgm:t>
    </dgm:pt>
    <dgm:pt modelId="{15BE9A04-9F86-45E4-8431-172B3BE52749}">
      <dgm:prSet phldrT="[Text]" custT="1"/>
      <dgm:spPr/>
      <dgm:t>
        <a:bodyPr/>
        <a:lstStyle/>
        <a:p>
          <a:r>
            <a:rPr lang="en-US" sz="1200" dirty="0" smtClean="0"/>
            <a:t>Process: 4</a:t>
          </a:r>
          <a:endParaRPr lang="en-US" sz="1200" dirty="0"/>
        </a:p>
      </dgm:t>
    </dgm:pt>
    <dgm:pt modelId="{9AE52F80-C0EC-46C4-BC4D-90B8E6E48B3D}" type="parTrans" cxnId="{B6DBACF4-F438-4A2C-BE21-8440A86AE7CB}">
      <dgm:prSet/>
      <dgm:spPr/>
      <dgm:t>
        <a:bodyPr/>
        <a:lstStyle/>
        <a:p>
          <a:endParaRPr lang="en-US"/>
        </a:p>
      </dgm:t>
    </dgm:pt>
    <dgm:pt modelId="{8EA255BC-6FEF-4A3A-BAC3-D56A58E8B0EA}" type="sibTrans" cxnId="{B6DBACF4-F438-4A2C-BE21-8440A86AE7CB}">
      <dgm:prSet/>
      <dgm:spPr/>
      <dgm:t>
        <a:bodyPr/>
        <a:lstStyle/>
        <a:p>
          <a:endParaRPr lang="en-US"/>
        </a:p>
      </dgm:t>
    </dgm:pt>
    <dgm:pt modelId="{6FE36E14-1528-48F8-8A99-16551612032F}">
      <dgm:prSet phldrT="[Text]" custT="1"/>
      <dgm:spPr/>
      <dgm:t>
        <a:bodyPr/>
        <a:lstStyle/>
        <a:p>
          <a:r>
            <a:rPr lang="en-US" sz="1200" dirty="0" smtClean="0"/>
            <a:t>Process: 5, 6</a:t>
          </a:r>
          <a:endParaRPr lang="en-US" sz="1200" dirty="0"/>
        </a:p>
      </dgm:t>
    </dgm:pt>
    <dgm:pt modelId="{03399614-0EC4-4A50-9A9B-BEB90EA6A23A}" type="parTrans" cxnId="{91122DDB-EC67-48B7-8B0F-FF7459494139}">
      <dgm:prSet/>
      <dgm:spPr/>
      <dgm:t>
        <a:bodyPr/>
        <a:lstStyle/>
        <a:p>
          <a:endParaRPr lang="en-US"/>
        </a:p>
      </dgm:t>
    </dgm:pt>
    <dgm:pt modelId="{868DE025-0B0B-4F34-8AA8-1EB42F1D0FAB}" type="sibTrans" cxnId="{91122DDB-EC67-48B7-8B0F-FF7459494139}">
      <dgm:prSet/>
      <dgm:spPr/>
      <dgm:t>
        <a:bodyPr/>
        <a:lstStyle/>
        <a:p>
          <a:endParaRPr lang="en-US"/>
        </a:p>
      </dgm:t>
    </dgm:pt>
    <dgm:pt modelId="{E71E88D5-6F7E-48C7-B81F-01FF125924EF}">
      <dgm:prSet phldrT="[Text]" custT="1"/>
      <dgm:spPr/>
      <dgm:t>
        <a:bodyPr/>
        <a:lstStyle/>
        <a:p>
          <a:r>
            <a:rPr lang="en-US" sz="1200" dirty="0" smtClean="0"/>
            <a:t>Process: 7</a:t>
          </a:r>
          <a:endParaRPr lang="en-US" sz="1200" dirty="0"/>
        </a:p>
      </dgm:t>
    </dgm:pt>
    <dgm:pt modelId="{1D33DB7D-FAF6-4237-9EB9-178520CE0B15}" type="parTrans" cxnId="{891D1E5E-B4BD-4290-83BC-153B4093A9C6}">
      <dgm:prSet/>
      <dgm:spPr/>
      <dgm:t>
        <a:bodyPr/>
        <a:lstStyle/>
        <a:p>
          <a:endParaRPr lang="en-US"/>
        </a:p>
      </dgm:t>
    </dgm:pt>
    <dgm:pt modelId="{F82A6917-D89D-4EC8-B95E-8DAF3EF89DA7}" type="sibTrans" cxnId="{891D1E5E-B4BD-4290-83BC-153B4093A9C6}">
      <dgm:prSet/>
      <dgm:spPr/>
      <dgm:t>
        <a:bodyPr/>
        <a:lstStyle/>
        <a:p>
          <a:endParaRPr lang="en-US"/>
        </a:p>
      </dgm:t>
    </dgm:pt>
    <dgm:pt modelId="{7E0CE677-352F-40A9-9304-3DD779B00BED}">
      <dgm:prSet custT="1"/>
      <dgm:spPr/>
      <dgm:t>
        <a:bodyPr/>
        <a:lstStyle/>
        <a:p>
          <a:r>
            <a:rPr lang="en-US" sz="1200" dirty="0" smtClean="0"/>
            <a:t>Process: 8, 9</a:t>
          </a:r>
          <a:endParaRPr lang="en-US" sz="1200" dirty="0"/>
        </a:p>
      </dgm:t>
    </dgm:pt>
    <dgm:pt modelId="{7809B364-3D89-4867-8C1C-41E56FDA0098}" type="parTrans" cxnId="{B731F56D-4EC3-4284-8E5D-FEBA7DD9A3E2}">
      <dgm:prSet/>
      <dgm:spPr/>
      <dgm:t>
        <a:bodyPr/>
        <a:lstStyle/>
        <a:p>
          <a:endParaRPr lang="en-US"/>
        </a:p>
      </dgm:t>
    </dgm:pt>
    <dgm:pt modelId="{988E9A70-33D1-452F-B5F4-845E450A7F00}" type="sibTrans" cxnId="{B731F56D-4EC3-4284-8E5D-FEBA7DD9A3E2}">
      <dgm:prSet/>
      <dgm:spPr/>
      <dgm:t>
        <a:bodyPr/>
        <a:lstStyle/>
        <a:p>
          <a:endParaRPr lang="en-US"/>
        </a:p>
      </dgm:t>
    </dgm:pt>
    <dgm:pt modelId="{EBAE398A-CCF9-483D-8CCA-563C0E32F3E5}">
      <dgm:prSet custT="1"/>
      <dgm:spPr/>
      <dgm:t>
        <a:bodyPr/>
        <a:lstStyle/>
        <a:p>
          <a:r>
            <a:rPr lang="en-US" sz="1200" dirty="0" smtClean="0"/>
            <a:t>Process: 10</a:t>
          </a:r>
          <a:endParaRPr lang="en-US" sz="1200" dirty="0"/>
        </a:p>
      </dgm:t>
    </dgm:pt>
    <dgm:pt modelId="{77C8517D-A338-4EFA-B774-E556DDF6A91D}" type="parTrans" cxnId="{3FD8DE38-2D04-4B07-90FB-1ED458551792}">
      <dgm:prSet/>
      <dgm:spPr/>
      <dgm:t>
        <a:bodyPr/>
        <a:lstStyle/>
        <a:p>
          <a:endParaRPr lang="en-US"/>
        </a:p>
      </dgm:t>
    </dgm:pt>
    <dgm:pt modelId="{CDF77F94-696C-47F9-A788-063ECD21E8E9}" type="sibTrans" cxnId="{3FD8DE38-2D04-4B07-90FB-1ED458551792}">
      <dgm:prSet/>
      <dgm:spPr/>
      <dgm:t>
        <a:bodyPr/>
        <a:lstStyle/>
        <a:p>
          <a:endParaRPr lang="en-US"/>
        </a:p>
      </dgm:t>
    </dgm:pt>
    <dgm:pt modelId="{6F6C975B-AB45-42ED-8379-5A0A2D73E614}">
      <dgm:prSet custT="1"/>
      <dgm:spPr/>
      <dgm:t>
        <a:bodyPr/>
        <a:lstStyle/>
        <a:p>
          <a:r>
            <a:rPr lang="en-US" sz="1200" dirty="0" smtClean="0"/>
            <a:t>Process: 11-18</a:t>
          </a:r>
          <a:endParaRPr lang="en-US" sz="1200" dirty="0"/>
        </a:p>
      </dgm:t>
    </dgm:pt>
    <dgm:pt modelId="{F0C7DDFB-ECDC-4653-A5CD-430D55CE16BA}" type="parTrans" cxnId="{75F3503A-DE0A-47A2-9635-B25FBB3A0418}">
      <dgm:prSet/>
      <dgm:spPr/>
      <dgm:t>
        <a:bodyPr/>
        <a:lstStyle/>
        <a:p>
          <a:endParaRPr lang="en-US"/>
        </a:p>
      </dgm:t>
    </dgm:pt>
    <dgm:pt modelId="{79422937-29F7-4FEA-875F-0462F827CC48}" type="sibTrans" cxnId="{75F3503A-DE0A-47A2-9635-B25FBB3A0418}">
      <dgm:prSet/>
      <dgm:spPr/>
      <dgm:t>
        <a:bodyPr/>
        <a:lstStyle/>
        <a:p>
          <a:endParaRPr lang="en-US"/>
        </a:p>
      </dgm:t>
    </dgm:pt>
    <dgm:pt modelId="{1AF8E8A9-B5E2-43C8-B4B2-4D1366CEE47D}" type="pres">
      <dgm:prSet presAssocID="{B77D6CE3-9C2F-4272-BA94-CFD6D1D0BF22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8F3C7176-83C7-4CB0-8D9D-A4455A7871BA}" type="pres">
      <dgm:prSet presAssocID="{B084E76E-5D59-47F6-AA35-C2AC3CE6E48D}" presName="composite" presStyleCnt="0"/>
      <dgm:spPr/>
    </dgm:pt>
    <dgm:pt modelId="{4A99B4EC-AB03-4B40-81C6-9A0881945147}" type="pres">
      <dgm:prSet presAssocID="{B084E76E-5D59-47F6-AA35-C2AC3CE6E48D}" presName="parTx" presStyleLbl="node1" presStyleIdx="0" presStyleCnt="6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C07CF835-FA85-45E7-B439-BF64CE7DBC45}" type="pres">
      <dgm:prSet presAssocID="{B084E76E-5D59-47F6-AA35-C2AC3CE6E48D}" presName="parSh" presStyleLbl="node1" presStyleIdx="0" presStyleCnt="6"/>
      <dgm:spPr/>
      <dgm:t>
        <a:bodyPr/>
        <a:lstStyle/>
        <a:p>
          <a:endParaRPr lang="en-US"/>
        </a:p>
      </dgm:t>
    </dgm:pt>
    <dgm:pt modelId="{5C8CFEB1-CFF5-4C4B-A39E-87137E304FD9}" type="pres">
      <dgm:prSet presAssocID="{B084E76E-5D59-47F6-AA35-C2AC3CE6E48D}" presName="desTx" presStyleLbl="fgAcc1" presStyleIdx="0" presStyleCnt="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73BADC3-E80F-4CDE-91A9-18383ED4500E}" type="pres">
      <dgm:prSet presAssocID="{8B3EAF7A-687C-47F4-A21D-9B7C76DDD00C}" presName="sibTrans" presStyleLbl="sibTrans2D1" presStyleIdx="0" presStyleCnt="5"/>
      <dgm:spPr/>
      <dgm:t>
        <a:bodyPr/>
        <a:lstStyle/>
        <a:p>
          <a:endParaRPr lang="en-US"/>
        </a:p>
      </dgm:t>
    </dgm:pt>
    <dgm:pt modelId="{94429B59-C6A4-4FC9-AD98-17253F360D78}" type="pres">
      <dgm:prSet presAssocID="{8B3EAF7A-687C-47F4-A21D-9B7C76DDD00C}" presName="connTx" presStyleLbl="sibTrans2D1" presStyleIdx="0" presStyleCnt="5"/>
      <dgm:spPr/>
      <dgm:t>
        <a:bodyPr/>
        <a:lstStyle/>
        <a:p>
          <a:endParaRPr lang="en-US"/>
        </a:p>
      </dgm:t>
    </dgm:pt>
    <dgm:pt modelId="{5E87A15A-8E0E-4BAE-8C15-CC63E83B8F80}" type="pres">
      <dgm:prSet presAssocID="{0A65F02B-27B3-4A9B-96CA-70BF9D829387}" presName="composite" presStyleCnt="0"/>
      <dgm:spPr/>
    </dgm:pt>
    <dgm:pt modelId="{6C978164-A4CD-416F-B231-FEC0A6E20034}" type="pres">
      <dgm:prSet presAssocID="{0A65F02B-27B3-4A9B-96CA-70BF9D829387}" presName="parTx" presStyleLbl="node1" presStyleIdx="0" presStyleCnt="6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424A88D-5EAC-4637-A2F6-AE61E5C72003}" type="pres">
      <dgm:prSet presAssocID="{0A65F02B-27B3-4A9B-96CA-70BF9D829387}" presName="parSh" presStyleLbl="node1" presStyleIdx="1" presStyleCnt="6"/>
      <dgm:spPr/>
      <dgm:t>
        <a:bodyPr/>
        <a:lstStyle/>
        <a:p>
          <a:endParaRPr lang="en-US"/>
        </a:p>
      </dgm:t>
    </dgm:pt>
    <dgm:pt modelId="{13505FC6-29D0-4A93-8A87-7155C657ACF6}" type="pres">
      <dgm:prSet presAssocID="{0A65F02B-27B3-4A9B-96CA-70BF9D829387}" presName="desTx" presStyleLbl="fgAcc1" presStyleIdx="1" presStyleCnt="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DA86C72-BC53-4CC2-9D19-D55678370E25}" type="pres">
      <dgm:prSet presAssocID="{BD53C65D-FB47-4739-B31D-6165D0FD9540}" presName="sibTrans" presStyleLbl="sibTrans2D1" presStyleIdx="1" presStyleCnt="5"/>
      <dgm:spPr/>
      <dgm:t>
        <a:bodyPr/>
        <a:lstStyle/>
        <a:p>
          <a:endParaRPr lang="en-US"/>
        </a:p>
      </dgm:t>
    </dgm:pt>
    <dgm:pt modelId="{CE053B66-8852-4625-A48C-841CA4B3D08F}" type="pres">
      <dgm:prSet presAssocID="{BD53C65D-FB47-4739-B31D-6165D0FD9540}" presName="connTx" presStyleLbl="sibTrans2D1" presStyleIdx="1" presStyleCnt="5"/>
      <dgm:spPr/>
      <dgm:t>
        <a:bodyPr/>
        <a:lstStyle/>
        <a:p>
          <a:endParaRPr lang="en-US"/>
        </a:p>
      </dgm:t>
    </dgm:pt>
    <dgm:pt modelId="{07BBEED7-1855-41BB-A4F9-FB6D14100D70}" type="pres">
      <dgm:prSet presAssocID="{1FBB9CCE-20BC-48D2-B0F4-DEB9678A127E}" presName="composite" presStyleCnt="0"/>
      <dgm:spPr/>
    </dgm:pt>
    <dgm:pt modelId="{35A19820-627E-4A00-9ED7-C4266509D37F}" type="pres">
      <dgm:prSet presAssocID="{1FBB9CCE-20BC-48D2-B0F4-DEB9678A127E}" presName="parTx" presStyleLbl="node1" presStyleIdx="1" presStyleCnt="6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69B0D89-131F-4C0C-B9B4-C116DC64450E}" type="pres">
      <dgm:prSet presAssocID="{1FBB9CCE-20BC-48D2-B0F4-DEB9678A127E}" presName="parSh" presStyleLbl="node1" presStyleIdx="2" presStyleCnt="6"/>
      <dgm:spPr/>
      <dgm:t>
        <a:bodyPr/>
        <a:lstStyle/>
        <a:p>
          <a:endParaRPr lang="en-US"/>
        </a:p>
      </dgm:t>
    </dgm:pt>
    <dgm:pt modelId="{714724DF-6F5C-4667-9018-22A6F0819D78}" type="pres">
      <dgm:prSet presAssocID="{1FBB9CCE-20BC-48D2-B0F4-DEB9678A127E}" presName="desTx" presStyleLbl="fgAcc1" presStyleIdx="2" presStyleCnt="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89757D1-85C2-4E9C-B9AE-4FFEE0D4011F}" type="pres">
      <dgm:prSet presAssocID="{B4EB7300-A9C9-409C-AA00-35284BA4A7D7}" presName="sibTrans" presStyleLbl="sibTrans2D1" presStyleIdx="2" presStyleCnt="5"/>
      <dgm:spPr/>
      <dgm:t>
        <a:bodyPr/>
        <a:lstStyle/>
        <a:p>
          <a:endParaRPr lang="en-US"/>
        </a:p>
      </dgm:t>
    </dgm:pt>
    <dgm:pt modelId="{3FD2B298-2AD1-4638-A6A3-77AA3627E904}" type="pres">
      <dgm:prSet presAssocID="{B4EB7300-A9C9-409C-AA00-35284BA4A7D7}" presName="connTx" presStyleLbl="sibTrans2D1" presStyleIdx="2" presStyleCnt="5"/>
      <dgm:spPr/>
      <dgm:t>
        <a:bodyPr/>
        <a:lstStyle/>
        <a:p>
          <a:endParaRPr lang="en-US"/>
        </a:p>
      </dgm:t>
    </dgm:pt>
    <dgm:pt modelId="{5A8FE4E1-12A8-40E3-A774-DA66C5C8F6FE}" type="pres">
      <dgm:prSet presAssocID="{4BDC33C0-A38F-41C4-A903-2D64017A6869}" presName="composite" presStyleCnt="0"/>
      <dgm:spPr/>
    </dgm:pt>
    <dgm:pt modelId="{EEDCC5C5-7FFE-45C5-A5A1-2078AD1D9FEB}" type="pres">
      <dgm:prSet presAssocID="{4BDC33C0-A38F-41C4-A903-2D64017A6869}" presName="parTx" presStyleLbl="node1" presStyleIdx="2" presStyleCnt="6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B07FB77-ED05-4CC0-8DB0-7D3070DAC231}" type="pres">
      <dgm:prSet presAssocID="{4BDC33C0-A38F-41C4-A903-2D64017A6869}" presName="parSh" presStyleLbl="node1" presStyleIdx="3" presStyleCnt="6"/>
      <dgm:spPr/>
      <dgm:t>
        <a:bodyPr/>
        <a:lstStyle/>
        <a:p>
          <a:endParaRPr lang="en-US"/>
        </a:p>
      </dgm:t>
    </dgm:pt>
    <dgm:pt modelId="{195F7E58-B89E-4B59-98B4-4C1431A1AF16}" type="pres">
      <dgm:prSet presAssocID="{4BDC33C0-A38F-41C4-A903-2D64017A6869}" presName="desTx" presStyleLbl="fgAcc1" presStyleIdx="3" presStyleCnt="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542ACB0-68E1-4865-A58F-0AD110188BD0}" type="pres">
      <dgm:prSet presAssocID="{83D9FD8C-D811-4DE7-9E07-0B3F9E365BBA}" presName="sibTrans" presStyleLbl="sibTrans2D1" presStyleIdx="3" presStyleCnt="5"/>
      <dgm:spPr/>
      <dgm:t>
        <a:bodyPr/>
        <a:lstStyle/>
        <a:p>
          <a:endParaRPr lang="en-US"/>
        </a:p>
      </dgm:t>
    </dgm:pt>
    <dgm:pt modelId="{49734521-2DE4-4F2F-B9D6-50747336FFAA}" type="pres">
      <dgm:prSet presAssocID="{83D9FD8C-D811-4DE7-9E07-0B3F9E365BBA}" presName="connTx" presStyleLbl="sibTrans2D1" presStyleIdx="3" presStyleCnt="5"/>
      <dgm:spPr/>
      <dgm:t>
        <a:bodyPr/>
        <a:lstStyle/>
        <a:p>
          <a:endParaRPr lang="en-US"/>
        </a:p>
      </dgm:t>
    </dgm:pt>
    <dgm:pt modelId="{FCFBB552-30F5-4323-9BF1-350EBF96CA84}" type="pres">
      <dgm:prSet presAssocID="{A950816C-6FDB-49C1-BC18-B3A22682E177}" presName="composite" presStyleCnt="0"/>
      <dgm:spPr/>
    </dgm:pt>
    <dgm:pt modelId="{0F21A8CA-AF01-4AA4-8C08-D7E393094716}" type="pres">
      <dgm:prSet presAssocID="{A950816C-6FDB-49C1-BC18-B3A22682E177}" presName="parTx" presStyleLbl="node1" presStyleIdx="3" presStyleCnt="6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448241C-0771-4138-AA03-756E37CD861A}" type="pres">
      <dgm:prSet presAssocID="{A950816C-6FDB-49C1-BC18-B3A22682E177}" presName="parSh" presStyleLbl="node1" presStyleIdx="4" presStyleCnt="6"/>
      <dgm:spPr/>
      <dgm:t>
        <a:bodyPr/>
        <a:lstStyle/>
        <a:p>
          <a:endParaRPr lang="en-US"/>
        </a:p>
      </dgm:t>
    </dgm:pt>
    <dgm:pt modelId="{62BDA506-A0F1-491E-BB98-887B6AF0AC58}" type="pres">
      <dgm:prSet presAssocID="{A950816C-6FDB-49C1-BC18-B3A22682E177}" presName="desTx" presStyleLbl="fgAcc1" presStyleIdx="4" presStyleCnt="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DF1C8D0-62BF-4EB6-8860-51E8F9E74E74}" type="pres">
      <dgm:prSet presAssocID="{669EA603-7D23-4134-AE75-7E5E129C9E8F}" presName="sibTrans" presStyleLbl="sibTrans2D1" presStyleIdx="4" presStyleCnt="5"/>
      <dgm:spPr/>
      <dgm:t>
        <a:bodyPr/>
        <a:lstStyle/>
        <a:p>
          <a:endParaRPr lang="en-US"/>
        </a:p>
      </dgm:t>
    </dgm:pt>
    <dgm:pt modelId="{DFCE544E-2307-4C1A-8E0F-4653ACF93BDE}" type="pres">
      <dgm:prSet presAssocID="{669EA603-7D23-4134-AE75-7E5E129C9E8F}" presName="connTx" presStyleLbl="sibTrans2D1" presStyleIdx="4" presStyleCnt="5"/>
      <dgm:spPr/>
      <dgm:t>
        <a:bodyPr/>
        <a:lstStyle/>
        <a:p>
          <a:endParaRPr lang="en-US"/>
        </a:p>
      </dgm:t>
    </dgm:pt>
    <dgm:pt modelId="{5C33C386-2E79-4271-A801-94657DED4AD6}" type="pres">
      <dgm:prSet presAssocID="{39ED8232-6914-426A-B41F-D31C3C5C1572}" presName="composite" presStyleCnt="0"/>
      <dgm:spPr/>
    </dgm:pt>
    <dgm:pt modelId="{4B7A7456-7F6A-4BC3-8591-3EBF5E1E910B}" type="pres">
      <dgm:prSet presAssocID="{39ED8232-6914-426A-B41F-D31C3C5C1572}" presName="parTx" presStyleLbl="node1" presStyleIdx="4" presStyleCnt="6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C21224D-F6F0-4B8F-B141-248FB806DB02}" type="pres">
      <dgm:prSet presAssocID="{39ED8232-6914-426A-B41F-D31C3C5C1572}" presName="parSh" presStyleLbl="node1" presStyleIdx="5" presStyleCnt="6"/>
      <dgm:spPr/>
      <dgm:t>
        <a:bodyPr/>
        <a:lstStyle/>
        <a:p>
          <a:endParaRPr lang="en-US"/>
        </a:p>
      </dgm:t>
    </dgm:pt>
    <dgm:pt modelId="{38A7CA3C-6AE6-4798-A503-6779B2997955}" type="pres">
      <dgm:prSet presAssocID="{39ED8232-6914-426A-B41F-D31C3C5C1572}" presName="desTx" presStyleLbl="fgAcc1" presStyleIdx="5" presStyleCnt="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2881B8B0-DDFF-40AE-BCF7-AAE0654A94E2}" srcId="{B77D6CE3-9C2F-4272-BA94-CFD6D1D0BF22}" destId="{39ED8232-6914-426A-B41F-D31C3C5C1572}" srcOrd="5" destOrd="0" parTransId="{80DB2170-397D-452E-862F-1F51F3E52D27}" sibTransId="{F6D5CB65-2408-4A7E-99FB-4229EE8081B1}"/>
    <dgm:cxn modelId="{DDF32B7E-CF51-4FFB-8C1B-92266EE7FE61}" type="presOf" srcId="{1FBB9CCE-20BC-48D2-B0F4-DEB9678A127E}" destId="{35A19820-627E-4A00-9ED7-C4266509D37F}" srcOrd="0" destOrd="0" presId="urn:microsoft.com/office/officeart/2005/8/layout/process3"/>
    <dgm:cxn modelId="{A6C563EA-F9D2-441F-8DBE-D99BF36BA9BB}" type="presOf" srcId="{BD53C65D-FB47-4739-B31D-6165D0FD9540}" destId="{6DA86C72-BC53-4CC2-9D19-D55678370E25}" srcOrd="0" destOrd="0" presId="urn:microsoft.com/office/officeart/2005/8/layout/process3"/>
    <dgm:cxn modelId="{8B2A7037-74AF-46F0-A412-DE7653539399}" type="presOf" srcId="{669EA603-7D23-4134-AE75-7E5E129C9E8F}" destId="{DDF1C8D0-62BF-4EB6-8860-51E8F9E74E74}" srcOrd="0" destOrd="0" presId="urn:microsoft.com/office/officeart/2005/8/layout/process3"/>
    <dgm:cxn modelId="{CAD8C11C-7E56-4337-8224-556DB593F28E}" type="presOf" srcId="{B084E76E-5D59-47F6-AA35-C2AC3CE6E48D}" destId="{4A99B4EC-AB03-4B40-81C6-9A0881945147}" srcOrd="0" destOrd="0" presId="urn:microsoft.com/office/officeart/2005/8/layout/process3"/>
    <dgm:cxn modelId="{787FBB3F-62AD-4F4A-8F13-898CA76AA692}" type="presOf" srcId="{15BE9A04-9F86-45E4-8431-172B3BE52749}" destId="{5C8CFEB1-CFF5-4C4B-A39E-87137E304FD9}" srcOrd="0" destOrd="1" presId="urn:microsoft.com/office/officeart/2005/8/layout/process3"/>
    <dgm:cxn modelId="{5D200B66-1FEA-496A-9ADA-D5E7C6FA0544}" type="presOf" srcId="{8B3EAF7A-687C-47F4-A21D-9B7C76DDD00C}" destId="{94429B59-C6A4-4FC9-AD98-17253F360D78}" srcOrd="1" destOrd="0" presId="urn:microsoft.com/office/officeart/2005/8/layout/process3"/>
    <dgm:cxn modelId="{F09EF029-9CC0-4049-8B7E-1332727D7D0B}" type="presOf" srcId="{B77D6CE3-9C2F-4272-BA94-CFD6D1D0BF22}" destId="{1AF8E8A9-B5E2-43C8-B4B2-4D1366CEE47D}" srcOrd="0" destOrd="0" presId="urn:microsoft.com/office/officeart/2005/8/layout/process3"/>
    <dgm:cxn modelId="{B6DBACF4-F438-4A2C-BE21-8440A86AE7CB}" srcId="{B084E76E-5D59-47F6-AA35-C2AC3CE6E48D}" destId="{15BE9A04-9F86-45E4-8431-172B3BE52749}" srcOrd="1" destOrd="0" parTransId="{9AE52F80-C0EC-46C4-BC4D-90B8E6E48B3D}" sibTransId="{8EA255BC-6FEF-4A3A-BAC3-D56A58E8B0EA}"/>
    <dgm:cxn modelId="{89DA2A8D-F404-4A90-B481-733F90A599EA}" type="presOf" srcId="{669EA603-7D23-4134-AE75-7E5E129C9E8F}" destId="{DFCE544E-2307-4C1A-8E0F-4653ACF93BDE}" srcOrd="1" destOrd="0" presId="urn:microsoft.com/office/officeart/2005/8/layout/process3"/>
    <dgm:cxn modelId="{891D1E5E-B4BD-4290-83BC-153B4093A9C6}" srcId="{1FBB9CCE-20BC-48D2-B0F4-DEB9678A127E}" destId="{E71E88D5-6F7E-48C7-B81F-01FF125924EF}" srcOrd="1" destOrd="0" parTransId="{1D33DB7D-FAF6-4237-9EB9-178520CE0B15}" sibTransId="{F82A6917-D89D-4EC8-B95E-8DAF3EF89DA7}"/>
    <dgm:cxn modelId="{FD5A8072-FC4F-4B9C-A978-19B96D845D3B}" type="presOf" srcId="{D71AF31F-0E14-4E3D-899F-9CFADD8ACB8E}" destId="{195F7E58-B89E-4B59-98B4-4C1431A1AF16}" srcOrd="0" destOrd="0" presId="urn:microsoft.com/office/officeart/2005/8/layout/process3"/>
    <dgm:cxn modelId="{91122DDB-EC67-48B7-8B0F-FF7459494139}" srcId="{0A65F02B-27B3-4A9B-96CA-70BF9D829387}" destId="{6FE36E14-1528-48F8-8A99-16551612032F}" srcOrd="1" destOrd="0" parTransId="{03399614-0EC4-4A50-9A9B-BEB90EA6A23A}" sibTransId="{868DE025-0B0B-4F34-8AA8-1EB42F1D0FAB}"/>
    <dgm:cxn modelId="{1714161E-FC0E-44D4-A35D-C6C93309461F}" type="presOf" srcId="{4DC91522-BD99-4926-98E2-E9BB7CB6B06B}" destId="{13505FC6-29D0-4A93-8A87-7155C657ACF6}" srcOrd="0" destOrd="0" presId="urn:microsoft.com/office/officeart/2005/8/layout/process3"/>
    <dgm:cxn modelId="{4A668FD6-BE04-43AA-BC4B-00942CB87554}" type="presOf" srcId="{EBAE398A-CCF9-483D-8CCA-563C0E32F3E5}" destId="{62BDA506-A0F1-491E-BB98-887B6AF0AC58}" srcOrd="0" destOrd="1" presId="urn:microsoft.com/office/officeart/2005/8/layout/process3"/>
    <dgm:cxn modelId="{70CA65F2-6292-47CD-9E27-F657DACB1168}" srcId="{A950816C-6FDB-49C1-BC18-B3A22682E177}" destId="{A52D4BAF-4EEB-45AD-A999-48FDF9E50EF0}" srcOrd="0" destOrd="0" parTransId="{12B01FCB-9A10-438C-BC20-5F8C9BEE0A55}" sibTransId="{9289D44E-17AA-460F-9025-F0944057AC28}"/>
    <dgm:cxn modelId="{0C54401C-3ED3-4A18-A0E9-BA1D4A6E9C5E}" type="presOf" srcId="{0A65F02B-27B3-4A9B-96CA-70BF9D829387}" destId="{6424A88D-5EAC-4637-A2F6-AE61E5C72003}" srcOrd="1" destOrd="0" presId="urn:microsoft.com/office/officeart/2005/8/layout/process3"/>
    <dgm:cxn modelId="{75F3503A-DE0A-47A2-9635-B25FBB3A0418}" srcId="{39ED8232-6914-426A-B41F-D31C3C5C1572}" destId="{6F6C975B-AB45-42ED-8379-5A0A2D73E614}" srcOrd="1" destOrd="0" parTransId="{F0C7DDFB-ECDC-4653-A5CD-430D55CE16BA}" sibTransId="{79422937-29F7-4FEA-875F-0462F827CC48}"/>
    <dgm:cxn modelId="{1903BEC5-14EC-4FA7-9280-68D3362ECDE7}" type="presOf" srcId="{8B3EAF7A-687C-47F4-A21D-9B7C76DDD00C}" destId="{573BADC3-E80F-4CDE-91A9-18383ED4500E}" srcOrd="0" destOrd="0" presId="urn:microsoft.com/office/officeart/2005/8/layout/process3"/>
    <dgm:cxn modelId="{2C567529-DC87-4743-8843-2B0687A566D4}" type="presOf" srcId="{39ED8232-6914-426A-B41F-D31C3C5C1572}" destId="{4B7A7456-7F6A-4BC3-8591-3EBF5E1E910B}" srcOrd="0" destOrd="0" presId="urn:microsoft.com/office/officeart/2005/8/layout/process3"/>
    <dgm:cxn modelId="{91609745-4D16-44CB-8429-D2F1951C8535}" type="presOf" srcId="{B93D8440-7DBC-4A03-BE58-22D44C980A52}" destId="{38A7CA3C-6AE6-4798-A503-6779B2997955}" srcOrd="0" destOrd="0" presId="urn:microsoft.com/office/officeart/2005/8/layout/process3"/>
    <dgm:cxn modelId="{11D2A740-034C-4059-BD3C-FD7AA972F0F9}" srcId="{1FBB9CCE-20BC-48D2-B0F4-DEB9678A127E}" destId="{BB591EEA-1176-4B1E-AA16-4DF85DE1EEB5}" srcOrd="0" destOrd="0" parTransId="{544FD8B5-6973-4AE9-949C-3319F4B8F7EB}" sibTransId="{317D6593-6D95-49B4-918D-AF6D0C0DE3B4}"/>
    <dgm:cxn modelId="{B731F56D-4EC3-4284-8E5D-FEBA7DD9A3E2}" srcId="{4BDC33C0-A38F-41C4-A903-2D64017A6869}" destId="{7E0CE677-352F-40A9-9304-3DD779B00BED}" srcOrd="1" destOrd="0" parTransId="{7809B364-3D89-4867-8C1C-41E56FDA0098}" sibTransId="{988E9A70-33D1-452F-B5F4-845E450A7F00}"/>
    <dgm:cxn modelId="{8577145E-7E3D-48D9-853B-33D653407968}" type="presOf" srcId="{6FE36E14-1528-48F8-8A99-16551612032F}" destId="{13505FC6-29D0-4A93-8A87-7155C657ACF6}" srcOrd="0" destOrd="1" presId="urn:microsoft.com/office/officeart/2005/8/layout/process3"/>
    <dgm:cxn modelId="{BE28DBBC-76D0-4B90-8534-B8A7DAA29042}" srcId="{B77D6CE3-9C2F-4272-BA94-CFD6D1D0BF22}" destId="{0A65F02B-27B3-4A9B-96CA-70BF9D829387}" srcOrd="1" destOrd="0" parTransId="{072DFE95-F855-4FDF-89BB-EFAE505818A0}" sibTransId="{BD53C65D-FB47-4739-B31D-6165D0FD9540}"/>
    <dgm:cxn modelId="{FC7F1763-4B8C-469D-8A85-424B28909658}" type="presOf" srcId="{6F6C975B-AB45-42ED-8379-5A0A2D73E614}" destId="{38A7CA3C-6AE6-4798-A503-6779B2997955}" srcOrd="0" destOrd="1" presId="urn:microsoft.com/office/officeart/2005/8/layout/process3"/>
    <dgm:cxn modelId="{35FDE11A-081D-41DF-B688-0B165F5CBD1A}" type="presOf" srcId="{0A65F02B-27B3-4A9B-96CA-70BF9D829387}" destId="{6C978164-A4CD-416F-B231-FEC0A6E20034}" srcOrd="0" destOrd="0" presId="urn:microsoft.com/office/officeart/2005/8/layout/process3"/>
    <dgm:cxn modelId="{7A49E4E9-F09D-4A5E-9DDD-49D48AAB8852}" type="presOf" srcId="{B084E76E-5D59-47F6-AA35-C2AC3CE6E48D}" destId="{C07CF835-FA85-45E7-B439-BF64CE7DBC45}" srcOrd="1" destOrd="0" presId="urn:microsoft.com/office/officeart/2005/8/layout/process3"/>
    <dgm:cxn modelId="{2348D880-A054-45FD-84CD-17EB017FB0AF}" type="presOf" srcId="{39ED8232-6914-426A-B41F-D31C3C5C1572}" destId="{9C21224D-F6F0-4B8F-B141-248FB806DB02}" srcOrd="1" destOrd="0" presId="urn:microsoft.com/office/officeart/2005/8/layout/process3"/>
    <dgm:cxn modelId="{11FFAC65-B993-4A2B-997E-01E906B40421}" type="presOf" srcId="{4BDC33C0-A38F-41C4-A903-2D64017A6869}" destId="{EEDCC5C5-7FFE-45C5-A5A1-2078AD1D9FEB}" srcOrd="0" destOrd="0" presId="urn:microsoft.com/office/officeart/2005/8/layout/process3"/>
    <dgm:cxn modelId="{DBD433F5-D95B-4ECF-9246-5297228E3C29}" type="presOf" srcId="{865FB31D-F3EA-4B0C-944A-3C4DDE361870}" destId="{5C8CFEB1-CFF5-4C4B-A39E-87137E304FD9}" srcOrd="0" destOrd="0" presId="urn:microsoft.com/office/officeart/2005/8/layout/process3"/>
    <dgm:cxn modelId="{035457EB-0A88-4571-96AF-782D3628DE29}" type="presOf" srcId="{4BDC33C0-A38F-41C4-A903-2D64017A6869}" destId="{5B07FB77-ED05-4CC0-8DB0-7D3070DAC231}" srcOrd="1" destOrd="0" presId="urn:microsoft.com/office/officeart/2005/8/layout/process3"/>
    <dgm:cxn modelId="{10AF2949-0316-42A2-A540-362CDBA3F800}" type="presOf" srcId="{7E0CE677-352F-40A9-9304-3DD779B00BED}" destId="{195F7E58-B89E-4B59-98B4-4C1431A1AF16}" srcOrd="0" destOrd="1" presId="urn:microsoft.com/office/officeart/2005/8/layout/process3"/>
    <dgm:cxn modelId="{A412FBB6-EEAD-49AB-84E5-05245F02D0C2}" srcId="{0A65F02B-27B3-4A9B-96CA-70BF9D829387}" destId="{4DC91522-BD99-4926-98E2-E9BB7CB6B06B}" srcOrd="0" destOrd="0" parTransId="{3766D76B-2DEE-40D6-AAFA-9B8636C715A5}" sibTransId="{810FE2D9-FFFB-43BF-8477-DCA4A6C13755}"/>
    <dgm:cxn modelId="{976710D4-1F34-461D-A3E1-FA3647CBBB51}" srcId="{B77D6CE3-9C2F-4272-BA94-CFD6D1D0BF22}" destId="{A950816C-6FDB-49C1-BC18-B3A22682E177}" srcOrd="4" destOrd="0" parTransId="{CA710D8C-7087-4B7F-81C1-E632808A93BF}" sibTransId="{669EA603-7D23-4134-AE75-7E5E129C9E8F}"/>
    <dgm:cxn modelId="{0A2211E3-0B7C-4945-AA53-E023472B7D76}" type="presOf" srcId="{83D9FD8C-D811-4DE7-9E07-0B3F9E365BBA}" destId="{2542ACB0-68E1-4865-A58F-0AD110188BD0}" srcOrd="0" destOrd="0" presId="urn:microsoft.com/office/officeart/2005/8/layout/process3"/>
    <dgm:cxn modelId="{BEB79D53-E897-464C-826F-E72D8A1ADA74}" type="presOf" srcId="{83D9FD8C-D811-4DE7-9E07-0B3F9E365BBA}" destId="{49734521-2DE4-4F2F-B9D6-50747336FFAA}" srcOrd="1" destOrd="0" presId="urn:microsoft.com/office/officeart/2005/8/layout/process3"/>
    <dgm:cxn modelId="{045F558A-B2A3-4689-8B3A-2125E38AF91B}" srcId="{B77D6CE3-9C2F-4272-BA94-CFD6D1D0BF22}" destId="{B084E76E-5D59-47F6-AA35-C2AC3CE6E48D}" srcOrd="0" destOrd="0" parTransId="{D44DC417-2815-4150-BD33-A6B5F3E4EF90}" sibTransId="{8B3EAF7A-687C-47F4-A21D-9B7C76DDD00C}"/>
    <dgm:cxn modelId="{416F468E-CECB-4859-B5F0-8F444C7E88EF}" srcId="{B77D6CE3-9C2F-4272-BA94-CFD6D1D0BF22}" destId="{1FBB9CCE-20BC-48D2-B0F4-DEB9678A127E}" srcOrd="2" destOrd="0" parTransId="{515EDF0C-EE15-4E6F-9947-5F03BB9C268A}" sibTransId="{B4EB7300-A9C9-409C-AA00-35284BA4A7D7}"/>
    <dgm:cxn modelId="{E1E25417-DAAB-4F02-BF9B-E19BBC8F8408}" srcId="{B77D6CE3-9C2F-4272-BA94-CFD6D1D0BF22}" destId="{4BDC33C0-A38F-41C4-A903-2D64017A6869}" srcOrd="3" destOrd="0" parTransId="{BAC386CD-22D4-4990-9F36-B6618FF60F75}" sibTransId="{83D9FD8C-D811-4DE7-9E07-0B3F9E365BBA}"/>
    <dgm:cxn modelId="{3FD8DE38-2D04-4B07-90FB-1ED458551792}" srcId="{A950816C-6FDB-49C1-BC18-B3A22682E177}" destId="{EBAE398A-CCF9-483D-8CCA-563C0E32F3E5}" srcOrd="1" destOrd="0" parTransId="{77C8517D-A338-4EFA-B774-E556DDF6A91D}" sibTransId="{CDF77F94-696C-47F9-A788-063ECD21E8E9}"/>
    <dgm:cxn modelId="{95453063-29FC-426D-9632-D43CB0D9A7C3}" type="presOf" srcId="{1FBB9CCE-20BC-48D2-B0F4-DEB9678A127E}" destId="{969B0D89-131F-4C0C-B9B4-C116DC64450E}" srcOrd="1" destOrd="0" presId="urn:microsoft.com/office/officeart/2005/8/layout/process3"/>
    <dgm:cxn modelId="{C8C71C43-D22F-4080-86F8-3977DDA46252}" type="presOf" srcId="{A950816C-6FDB-49C1-BC18-B3A22682E177}" destId="{7448241C-0771-4138-AA03-756E37CD861A}" srcOrd="1" destOrd="0" presId="urn:microsoft.com/office/officeart/2005/8/layout/process3"/>
    <dgm:cxn modelId="{A8FF86D5-2CDD-4C1D-A31C-3E5685CD749E}" type="presOf" srcId="{A950816C-6FDB-49C1-BC18-B3A22682E177}" destId="{0F21A8CA-AF01-4AA4-8C08-D7E393094716}" srcOrd="0" destOrd="0" presId="urn:microsoft.com/office/officeart/2005/8/layout/process3"/>
    <dgm:cxn modelId="{ECDF3B75-3C58-4DDF-9B59-39D37DB28DD9}" type="presOf" srcId="{BB591EEA-1176-4B1E-AA16-4DF85DE1EEB5}" destId="{714724DF-6F5C-4667-9018-22A6F0819D78}" srcOrd="0" destOrd="0" presId="urn:microsoft.com/office/officeart/2005/8/layout/process3"/>
    <dgm:cxn modelId="{05E1ACBE-F888-4F00-85FC-525CE1823C59}" type="presOf" srcId="{BD53C65D-FB47-4739-B31D-6165D0FD9540}" destId="{CE053B66-8852-4625-A48C-841CA4B3D08F}" srcOrd="1" destOrd="0" presId="urn:microsoft.com/office/officeart/2005/8/layout/process3"/>
    <dgm:cxn modelId="{F92BA476-192E-48F5-B968-AE78CE3F6E9E}" type="presOf" srcId="{B4EB7300-A9C9-409C-AA00-35284BA4A7D7}" destId="{3FD2B298-2AD1-4638-A6A3-77AA3627E904}" srcOrd="1" destOrd="0" presId="urn:microsoft.com/office/officeart/2005/8/layout/process3"/>
    <dgm:cxn modelId="{6B6C0A2F-56E6-49B1-8797-4A72BB7C0CE8}" srcId="{39ED8232-6914-426A-B41F-D31C3C5C1572}" destId="{B93D8440-7DBC-4A03-BE58-22D44C980A52}" srcOrd="0" destOrd="0" parTransId="{7ECBB7E3-CBFB-42CF-A25F-EB8C17C5F9D1}" sibTransId="{17576FED-3B7E-4F57-873D-AE297F002AED}"/>
    <dgm:cxn modelId="{B4E36E29-3109-4D89-92E1-D5ABCA8CE81B}" type="presOf" srcId="{B4EB7300-A9C9-409C-AA00-35284BA4A7D7}" destId="{289757D1-85C2-4E9C-B9AE-4FFEE0D4011F}" srcOrd="0" destOrd="0" presId="urn:microsoft.com/office/officeart/2005/8/layout/process3"/>
    <dgm:cxn modelId="{CDEE0858-74A7-42F3-BD51-16F36E979F5A}" srcId="{B084E76E-5D59-47F6-AA35-C2AC3CE6E48D}" destId="{865FB31D-F3EA-4B0C-944A-3C4DDE361870}" srcOrd="0" destOrd="0" parTransId="{B791EE00-3CA1-49FC-B331-CAF8A29C5562}" sibTransId="{E7339645-DB51-401C-AF13-946FDF0EAF09}"/>
    <dgm:cxn modelId="{86059CE8-E9D1-4782-A579-E802F543CFDF}" type="presOf" srcId="{A52D4BAF-4EEB-45AD-A999-48FDF9E50EF0}" destId="{62BDA506-A0F1-491E-BB98-887B6AF0AC58}" srcOrd="0" destOrd="0" presId="urn:microsoft.com/office/officeart/2005/8/layout/process3"/>
    <dgm:cxn modelId="{5C8B003F-5C26-483E-A4C4-A38B6CD729E9}" srcId="{4BDC33C0-A38F-41C4-A903-2D64017A6869}" destId="{D71AF31F-0E14-4E3D-899F-9CFADD8ACB8E}" srcOrd="0" destOrd="0" parTransId="{B042C0C1-B933-4206-9B29-51FC9100CBB9}" sibTransId="{DC4E7D7F-AACE-4874-8D47-4C5830753530}"/>
    <dgm:cxn modelId="{E7D81D44-038A-4B5A-9277-04BA8BF74B0C}" type="presOf" srcId="{E71E88D5-6F7E-48C7-B81F-01FF125924EF}" destId="{714724DF-6F5C-4667-9018-22A6F0819D78}" srcOrd="0" destOrd="1" presId="urn:microsoft.com/office/officeart/2005/8/layout/process3"/>
    <dgm:cxn modelId="{1B3549E5-3E57-4620-92B4-221DE640BE6B}" type="presParOf" srcId="{1AF8E8A9-B5E2-43C8-B4B2-4D1366CEE47D}" destId="{8F3C7176-83C7-4CB0-8D9D-A4455A7871BA}" srcOrd="0" destOrd="0" presId="urn:microsoft.com/office/officeart/2005/8/layout/process3"/>
    <dgm:cxn modelId="{EC8A65A0-2ED0-4C6F-80AD-B4E73B408523}" type="presParOf" srcId="{8F3C7176-83C7-4CB0-8D9D-A4455A7871BA}" destId="{4A99B4EC-AB03-4B40-81C6-9A0881945147}" srcOrd="0" destOrd="0" presId="urn:microsoft.com/office/officeart/2005/8/layout/process3"/>
    <dgm:cxn modelId="{2BD253F1-F88E-4322-9F65-D723CE89C392}" type="presParOf" srcId="{8F3C7176-83C7-4CB0-8D9D-A4455A7871BA}" destId="{C07CF835-FA85-45E7-B439-BF64CE7DBC45}" srcOrd="1" destOrd="0" presId="urn:microsoft.com/office/officeart/2005/8/layout/process3"/>
    <dgm:cxn modelId="{9074701F-F9B8-4FE6-B983-68305F6BDC98}" type="presParOf" srcId="{8F3C7176-83C7-4CB0-8D9D-A4455A7871BA}" destId="{5C8CFEB1-CFF5-4C4B-A39E-87137E304FD9}" srcOrd="2" destOrd="0" presId="urn:microsoft.com/office/officeart/2005/8/layout/process3"/>
    <dgm:cxn modelId="{4C13E6B7-F4AD-4DFF-9586-88CA802E9DA7}" type="presParOf" srcId="{1AF8E8A9-B5E2-43C8-B4B2-4D1366CEE47D}" destId="{573BADC3-E80F-4CDE-91A9-18383ED4500E}" srcOrd="1" destOrd="0" presId="urn:microsoft.com/office/officeart/2005/8/layout/process3"/>
    <dgm:cxn modelId="{43968B75-8DF0-4EAF-B636-7F23F273C146}" type="presParOf" srcId="{573BADC3-E80F-4CDE-91A9-18383ED4500E}" destId="{94429B59-C6A4-4FC9-AD98-17253F360D78}" srcOrd="0" destOrd="0" presId="urn:microsoft.com/office/officeart/2005/8/layout/process3"/>
    <dgm:cxn modelId="{7C7F891E-638E-4993-8560-89228F76701F}" type="presParOf" srcId="{1AF8E8A9-B5E2-43C8-B4B2-4D1366CEE47D}" destId="{5E87A15A-8E0E-4BAE-8C15-CC63E83B8F80}" srcOrd="2" destOrd="0" presId="urn:microsoft.com/office/officeart/2005/8/layout/process3"/>
    <dgm:cxn modelId="{DD60CE5F-4256-49E3-9A90-3C2D2247019B}" type="presParOf" srcId="{5E87A15A-8E0E-4BAE-8C15-CC63E83B8F80}" destId="{6C978164-A4CD-416F-B231-FEC0A6E20034}" srcOrd="0" destOrd="0" presId="urn:microsoft.com/office/officeart/2005/8/layout/process3"/>
    <dgm:cxn modelId="{66BE4656-43C5-4582-998B-D9B4722430A4}" type="presParOf" srcId="{5E87A15A-8E0E-4BAE-8C15-CC63E83B8F80}" destId="{6424A88D-5EAC-4637-A2F6-AE61E5C72003}" srcOrd="1" destOrd="0" presId="urn:microsoft.com/office/officeart/2005/8/layout/process3"/>
    <dgm:cxn modelId="{9BED655E-1BE8-4485-8952-EFFDC1E46F41}" type="presParOf" srcId="{5E87A15A-8E0E-4BAE-8C15-CC63E83B8F80}" destId="{13505FC6-29D0-4A93-8A87-7155C657ACF6}" srcOrd="2" destOrd="0" presId="urn:microsoft.com/office/officeart/2005/8/layout/process3"/>
    <dgm:cxn modelId="{CD60FD03-91E5-4C87-B02F-24B8AB97EFF0}" type="presParOf" srcId="{1AF8E8A9-B5E2-43C8-B4B2-4D1366CEE47D}" destId="{6DA86C72-BC53-4CC2-9D19-D55678370E25}" srcOrd="3" destOrd="0" presId="urn:microsoft.com/office/officeart/2005/8/layout/process3"/>
    <dgm:cxn modelId="{206C0991-12CD-4485-8F23-2417CA208D4F}" type="presParOf" srcId="{6DA86C72-BC53-4CC2-9D19-D55678370E25}" destId="{CE053B66-8852-4625-A48C-841CA4B3D08F}" srcOrd="0" destOrd="0" presId="urn:microsoft.com/office/officeart/2005/8/layout/process3"/>
    <dgm:cxn modelId="{A0D28A52-606D-4632-A5EA-59308DB4C235}" type="presParOf" srcId="{1AF8E8A9-B5E2-43C8-B4B2-4D1366CEE47D}" destId="{07BBEED7-1855-41BB-A4F9-FB6D14100D70}" srcOrd="4" destOrd="0" presId="urn:microsoft.com/office/officeart/2005/8/layout/process3"/>
    <dgm:cxn modelId="{86570167-71F4-4A22-A4DC-2B3CF774937C}" type="presParOf" srcId="{07BBEED7-1855-41BB-A4F9-FB6D14100D70}" destId="{35A19820-627E-4A00-9ED7-C4266509D37F}" srcOrd="0" destOrd="0" presId="urn:microsoft.com/office/officeart/2005/8/layout/process3"/>
    <dgm:cxn modelId="{C1DB92F7-F684-4277-BDCF-02DD8DF2C32A}" type="presParOf" srcId="{07BBEED7-1855-41BB-A4F9-FB6D14100D70}" destId="{969B0D89-131F-4C0C-B9B4-C116DC64450E}" srcOrd="1" destOrd="0" presId="urn:microsoft.com/office/officeart/2005/8/layout/process3"/>
    <dgm:cxn modelId="{29540B6E-64EB-4D73-983D-F9916CCF7752}" type="presParOf" srcId="{07BBEED7-1855-41BB-A4F9-FB6D14100D70}" destId="{714724DF-6F5C-4667-9018-22A6F0819D78}" srcOrd="2" destOrd="0" presId="urn:microsoft.com/office/officeart/2005/8/layout/process3"/>
    <dgm:cxn modelId="{AB22A3B2-DAF6-41B3-8685-82A31E0F783D}" type="presParOf" srcId="{1AF8E8A9-B5E2-43C8-B4B2-4D1366CEE47D}" destId="{289757D1-85C2-4E9C-B9AE-4FFEE0D4011F}" srcOrd="5" destOrd="0" presId="urn:microsoft.com/office/officeart/2005/8/layout/process3"/>
    <dgm:cxn modelId="{58098039-7404-4BA5-A03E-4756B5882F93}" type="presParOf" srcId="{289757D1-85C2-4E9C-B9AE-4FFEE0D4011F}" destId="{3FD2B298-2AD1-4638-A6A3-77AA3627E904}" srcOrd="0" destOrd="0" presId="urn:microsoft.com/office/officeart/2005/8/layout/process3"/>
    <dgm:cxn modelId="{26096EB5-78AD-46C9-ADE6-4F16D8BEAEFE}" type="presParOf" srcId="{1AF8E8A9-B5E2-43C8-B4B2-4D1366CEE47D}" destId="{5A8FE4E1-12A8-40E3-A774-DA66C5C8F6FE}" srcOrd="6" destOrd="0" presId="urn:microsoft.com/office/officeart/2005/8/layout/process3"/>
    <dgm:cxn modelId="{B3E4D69A-308C-4F08-91B7-D6A71E0CBA3C}" type="presParOf" srcId="{5A8FE4E1-12A8-40E3-A774-DA66C5C8F6FE}" destId="{EEDCC5C5-7FFE-45C5-A5A1-2078AD1D9FEB}" srcOrd="0" destOrd="0" presId="urn:microsoft.com/office/officeart/2005/8/layout/process3"/>
    <dgm:cxn modelId="{87CD149C-CC52-4E76-A099-E235AC2E416F}" type="presParOf" srcId="{5A8FE4E1-12A8-40E3-A774-DA66C5C8F6FE}" destId="{5B07FB77-ED05-4CC0-8DB0-7D3070DAC231}" srcOrd="1" destOrd="0" presId="urn:microsoft.com/office/officeart/2005/8/layout/process3"/>
    <dgm:cxn modelId="{3A170802-A194-42BE-A0F1-EE2DDFC0D3B6}" type="presParOf" srcId="{5A8FE4E1-12A8-40E3-A774-DA66C5C8F6FE}" destId="{195F7E58-B89E-4B59-98B4-4C1431A1AF16}" srcOrd="2" destOrd="0" presId="urn:microsoft.com/office/officeart/2005/8/layout/process3"/>
    <dgm:cxn modelId="{2EFE4D2C-06C2-47DB-ADB0-4E4A1BEC462D}" type="presParOf" srcId="{1AF8E8A9-B5E2-43C8-B4B2-4D1366CEE47D}" destId="{2542ACB0-68E1-4865-A58F-0AD110188BD0}" srcOrd="7" destOrd="0" presId="urn:microsoft.com/office/officeart/2005/8/layout/process3"/>
    <dgm:cxn modelId="{919BB464-A600-4377-93EC-9407542C2BFD}" type="presParOf" srcId="{2542ACB0-68E1-4865-A58F-0AD110188BD0}" destId="{49734521-2DE4-4F2F-B9D6-50747336FFAA}" srcOrd="0" destOrd="0" presId="urn:microsoft.com/office/officeart/2005/8/layout/process3"/>
    <dgm:cxn modelId="{7576DFFA-109E-4BB7-A525-0EC62083B5E6}" type="presParOf" srcId="{1AF8E8A9-B5E2-43C8-B4B2-4D1366CEE47D}" destId="{FCFBB552-30F5-4323-9BF1-350EBF96CA84}" srcOrd="8" destOrd="0" presId="urn:microsoft.com/office/officeart/2005/8/layout/process3"/>
    <dgm:cxn modelId="{E3F460CB-1D89-4C66-8492-8C2D8339FEA5}" type="presParOf" srcId="{FCFBB552-30F5-4323-9BF1-350EBF96CA84}" destId="{0F21A8CA-AF01-4AA4-8C08-D7E393094716}" srcOrd="0" destOrd="0" presId="urn:microsoft.com/office/officeart/2005/8/layout/process3"/>
    <dgm:cxn modelId="{99E0C02F-11C6-401C-B67A-AC21D4D5042D}" type="presParOf" srcId="{FCFBB552-30F5-4323-9BF1-350EBF96CA84}" destId="{7448241C-0771-4138-AA03-756E37CD861A}" srcOrd="1" destOrd="0" presId="urn:microsoft.com/office/officeart/2005/8/layout/process3"/>
    <dgm:cxn modelId="{91A08247-3997-4834-A7EC-937F13AC4AF3}" type="presParOf" srcId="{FCFBB552-30F5-4323-9BF1-350EBF96CA84}" destId="{62BDA506-A0F1-491E-BB98-887B6AF0AC58}" srcOrd="2" destOrd="0" presId="urn:microsoft.com/office/officeart/2005/8/layout/process3"/>
    <dgm:cxn modelId="{51D45191-FAE8-485A-B3DC-797349C7FEC1}" type="presParOf" srcId="{1AF8E8A9-B5E2-43C8-B4B2-4D1366CEE47D}" destId="{DDF1C8D0-62BF-4EB6-8860-51E8F9E74E74}" srcOrd="9" destOrd="0" presId="urn:microsoft.com/office/officeart/2005/8/layout/process3"/>
    <dgm:cxn modelId="{B15C5CAD-CCFE-4DF2-8D45-D670C8CCC1F8}" type="presParOf" srcId="{DDF1C8D0-62BF-4EB6-8860-51E8F9E74E74}" destId="{DFCE544E-2307-4C1A-8E0F-4653ACF93BDE}" srcOrd="0" destOrd="0" presId="urn:microsoft.com/office/officeart/2005/8/layout/process3"/>
    <dgm:cxn modelId="{8E1038CF-20FC-44C0-B93C-E210891C3D20}" type="presParOf" srcId="{1AF8E8A9-B5E2-43C8-B4B2-4D1366CEE47D}" destId="{5C33C386-2E79-4271-A801-94657DED4AD6}" srcOrd="10" destOrd="0" presId="urn:microsoft.com/office/officeart/2005/8/layout/process3"/>
    <dgm:cxn modelId="{F38619B9-889B-483F-8F87-95C2BB89545A}" type="presParOf" srcId="{5C33C386-2E79-4271-A801-94657DED4AD6}" destId="{4B7A7456-7F6A-4BC3-8591-3EBF5E1E910B}" srcOrd="0" destOrd="0" presId="urn:microsoft.com/office/officeart/2005/8/layout/process3"/>
    <dgm:cxn modelId="{931B1AD8-E52A-41D9-8F1E-41864C19B43F}" type="presParOf" srcId="{5C33C386-2E79-4271-A801-94657DED4AD6}" destId="{9C21224D-F6F0-4B8F-B141-248FB806DB02}" srcOrd="1" destOrd="0" presId="urn:microsoft.com/office/officeart/2005/8/layout/process3"/>
    <dgm:cxn modelId="{9B62CD22-36BE-46C8-9CC2-D5CD1991C05B}" type="presParOf" srcId="{5C33C386-2E79-4271-A801-94657DED4AD6}" destId="{38A7CA3C-6AE6-4798-A503-6779B2997955}" srcOrd="2" destOrd="0" presId="urn:microsoft.com/office/officeart/2005/8/layout/process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07CF835-FA85-45E7-B439-BF64CE7DBC45}">
      <dsp:nvSpPr>
        <dsp:cNvPr id="0" name=""/>
        <dsp:cNvSpPr/>
      </dsp:nvSpPr>
      <dsp:spPr>
        <a:xfrm>
          <a:off x="16146" y="178685"/>
          <a:ext cx="1281920" cy="52806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err="1" smtClean="0"/>
            <a:t>BCraw</a:t>
          </a:r>
          <a:endParaRPr lang="en-US" sz="1400" kern="1200" dirty="0"/>
        </a:p>
      </dsp:txBody>
      <dsp:txXfrm>
        <a:off x="16146" y="178685"/>
        <a:ext cx="1281920" cy="352044"/>
      </dsp:txXfrm>
    </dsp:sp>
    <dsp:sp modelId="{5C8CFEB1-CFF5-4C4B-A39E-87137E304FD9}">
      <dsp:nvSpPr>
        <dsp:cNvPr id="0" name=""/>
        <dsp:cNvSpPr/>
      </dsp:nvSpPr>
      <dsp:spPr>
        <a:xfrm>
          <a:off x="278452" y="530730"/>
          <a:ext cx="1281920" cy="1476000"/>
        </a:xfrm>
        <a:prstGeom prst="roundRect">
          <a:avLst>
            <a:gd name="adj" fmla="val 10000"/>
          </a:avLst>
        </a:prstGeom>
        <a:solidFill>
          <a:schemeClr val="accent2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Barcode-split individual sample sequence files (Sample.1.fq, Sample.2.fq) </a:t>
          </a:r>
          <a:endParaRPr lang="en-US" sz="12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Process: 4</a:t>
          </a:r>
          <a:endParaRPr lang="en-US" sz="1200" kern="1200" dirty="0"/>
        </a:p>
      </dsp:txBody>
      <dsp:txXfrm>
        <a:off x="315998" y="568276"/>
        <a:ext cx="1206828" cy="1400908"/>
      </dsp:txXfrm>
    </dsp:sp>
    <dsp:sp modelId="{573BADC3-E80F-4CDE-91A9-18383ED4500E}">
      <dsp:nvSpPr>
        <dsp:cNvPr id="0" name=""/>
        <dsp:cNvSpPr/>
      </dsp:nvSpPr>
      <dsp:spPr>
        <a:xfrm>
          <a:off x="1492359" y="195100"/>
          <a:ext cx="411898" cy="319214"/>
        </a:xfrm>
        <a:prstGeom prst="rightArrow">
          <a:avLst>
            <a:gd name="adj1" fmla="val 60000"/>
            <a:gd name="adj2" fmla="val 50000"/>
          </a:avLst>
        </a:prstGeom>
        <a:solidFill>
          <a:schemeClr val="accent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1492359" y="258943"/>
        <a:ext cx="316134" cy="191528"/>
      </dsp:txXfrm>
    </dsp:sp>
    <dsp:sp modelId="{6424A88D-5EAC-4637-A2F6-AE61E5C72003}">
      <dsp:nvSpPr>
        <dsp:cNvPr id="0" name=""/>
        <dsp:cNvSpPr/>
      </dsp:nvSpPr>
      <dsp:spPr>
        <a:xfrm>
          <a:off x="2075234" y="178685"/>
          <a:ext cx="1281920" cy="52806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err="1" smtClean="0"/>
            <a:t>BCpc</a:t>
          </a:r>
          <a:endParaRPr lang="en-US" sz="1400" kern="1200" dirty="0"/>
        </a:p>
      </dsp:txBody>
      <dsp:txXfrm>
        <a:off x="2075234" y="178685"/>
        <a:ext cx="1281920" cy="352044"/>
      </dsp:txXfrm>
    </dsp:sp>
    <dsp:sp modelId="{13505FC6-29D0-4A93-8A87-7155C657ACF6}">
      <dsp:nvSpPr>
        <dsp:cNvPr id="0" name=""/>
        <dsp:cNvSpPr/>
      </dsp:nvSpPr>
      <dsp:spPr>
        <a:xfrm>
          <a:off x="2337540" y="530730"/>
          <a:ext cx="1281920" cy="1476000"/>
        </a:xfrm>
        <a:prstGeom prst="roundRect">
          <a:avLst>
            <a:gd name="adj" fmla="val 10000"/>
          </a:avLst>
        </a:prstGeom>
        <a:solidFill>
          <a:schemeClr val="accent2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Trimmed sequence files (Sample.1.fq, Sample.2.fq)</a:t>
          </a:r>
          <a:endParaRPr lang="en-US" sz="12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Process: 5, 6</a:t>
          </a:r>
          <a:endParaRPr lang="en-US" sz="1200" kern="1200" dirty="0"/>
        </a:p>
      </dsp:txBody>
      <dsp:txXfrm>
        <a:off x="2375086" y="568276"/>
        <a:ext cx="1206828" cy="1400908"/>
      </dsp:txXfrm>
    </dsp:sp>
    <dsp:sp modelId="{6DA86C72-BC53-4CC2-9D19-D55678370E25}">
      <dsp:nvSpPr>
        <dsp:cNvPr id="0" name=""/>
        <dsp:cNvSpPr/>
      </dsp:nvSpPr>
      <dsp:spPr>
        <a:xfrm>
          <a:off x="3551447" y="195100"/>
          <a:ext cx="411898" cy="319214"/>
        </a:xfrm>
        <a:prstGeom prst="rightArrow">
          <a:avLst>
            <a:gd name="adj1" fmla="val 60000"/>
            <a:gd name="adj2" fmla="val 50000"/>
          </a:avLst>
        </a:prstGeom>
        <a:solidFill>
          <a:schemeClr val="accent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3551447" y="258943"/>
        <a:ext cx="316134" cy="191528"/>
      </dsp:txXfrm>
    </dsp:sp>
    <dsp:sp modelId="{969B0D89-131F-4C0C-B9B4-C116DC64450E}">
      <dsp:nvSpPr>
        <dsp:cNvPr id="0" name=""/>
        <dsp:cNvSpPr/>
      </dsp:nvSpPr>
      <dsp:spPr>
        <a:xfrm>
          <a:off x="4134322" y="178685"/>
          <a:ext cx="1281920" cy="52806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err="1" smtClean="0"/>
            <a:t>BCfin</a:t>
          </a:r>
          <a:endParaRPr lang="en-US" sz="1400" kern="1200" dirty="0"/>
        </a:p>
      </dsp:txBody>
      <dsp:txXfrm>
        <a:off x="4134322" y="178685"/>
        <a:ext cx="1281920" cy="352044"/>
      </dsp:txXfrm>
    </dsp:sp>
    <dsp:sp modelId="{714724DF-6F5C-4667-9018-22A6F0819D78}">
      <dsp:nvSpPr>
        <dsp:cNvPr id="0" name=""/>
        <dsp:cNvSpPr/>
      </dsp:nvSpPr>
      <dsp:spPr>
        <a:xfrm>
          <a:off x="4396628" y="530730"/>
          <a:ext cx="1281920" cy="1476000"/>
        </a:xfrm>
        <a:prstGeom prst="roundRect">
          <a:avLst>
            <a:gd name="adj" fmla="val 10000"/>
          </a:avLst>
        </a:prstGeom>
        <a:solidFill>
          <a:schemeClr val="accent2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Equal-length sequence files (</a:t>
          </a:r>
          <a:r>
            <a:rPr lang="en-US" sz="1200" kern="1200" dirty="0" err="1" smtClean="0"/>
            <a:t>Sample.fq</a:t>
          </a:r>
          <a:r>
            <a:rPr lang="en-US" sz="1200" kern="1200" dirty="0" smtClean="0"/>
            <a:t>)</a:t>
          </a:r>
          <a:endParaRPr lang="en-US" sz="12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Process: 7</a:t>
          </a:r>
          <a:endParaRPr lang="en-US" sz="1200" kern="1200" dirty="0"/>
        </a:p>
      </dsp:txBody>
      <dsp:txXfrm>
        <a:off x="4434174" y="568276"/>
        <a:ext cx="1206828" cy="1400908"/>
      </dsp:txXfrm>
    </dsp:sp>
    <dsp:sp modelId="{289757D1-85C2-4E9C-B9AE-4FFEE0D4011F}">
      <dsp:nvSpPr>
        <dsp:cNvPr id="0" name=""/>
        <dsp:cNvSpPr/>
      </dsp:nvSpPr>
      <dsp:spPr>
        <a:xfrm>
          <a:off x="5610535" y="195100"/>
          <a:ext cx="411898" cy="319214"/>
        </a:xfrm>
        <a:prstGeom prst="rightArrow">
          <a:avLst>
            <a:gd name="adj1" fmla="val 60000"/>
            <a:gd name="adj2" fmla="val 50000"/>
          </a:avLst>
        </a:prstGeom>
        <a:solidFill>
          <a:schemeClr val="accent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5610535" y="258943"/>
        <a:ext cx="316134" cy="191528"/>
      </dsp:txXfrm>
    </dsp:sp>
    <dsp:sp modelId="{5B07FB77-ED05-4CC0-8DB0-7D3070DAC231}">
      <dsp:nvSpPr>
        <dsp:cNvPr id="0" name=""/>
        <dsp:cNvSpPr/>
      </dsp:nvSpPr>
      <dsp:spPr>
        <a:xfrm>
          <a:off x="6193410" y="178685"/>
          <a:ext cx="1281920" cy="52806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/>
            <a:t>ASU</a:t>
          </a:r>
          <a:endParaRPr lang="en-US" sz="1400" kern="1200" dirty="0"/>
        </a:p>
      </dsp:txBody>
      <dsp:txXfrm>
        <a:off x="6193410" y="178685"/>
        <a:ext cx="1281920" cy="352044"/>
      </dsp:txXfrm>
    </dsp:sp>
    <dsp:sp modelId="{195F7E58-B89E-4B59-98B4-4C1431A1AF16}">
      <dsp:nvSpPr>
        <dsp:cNvPr id="0" name=""/>
        <dsp:cNvSpPr/>
      </dsp:nvSpPr>
      <dsp:spPr>
        <a:xfrm>
          <a:off x="6455716" y="530730"/>
          <a:ext cx="1281920" cy="1476000"/>
        </a:xfrm>
        <a:prstGeom prst="roundRect">
          <a:avLst>
            <a:gd name="adj" fmla="val 10000"/>
          </a:avLst>
        </a:prstGeom>
        <a:solidFill>
          <a:schemeClr val="accent2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ASU files for each sample (</a:t>
          </a:r>
          <a:r>
            <a:rPr lang="en-US" sz="1200" kern="1200" dirty="0" err="1" smtClean="0"/>
            <a:t>Sample.tags.tsv</a:t>
          </a:r>
          <a:r>
            <a:rPr lang="en-US" sz="1200" kern="1200" dirty="0" smtClean="0"/>
            <a:t>)</a:t>
          </a:r>
          <a:endParaRPr lang="en-US" sz="12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Process: 8, 9</a:t>
          </a:r>
          <a:endParaRPr lang="en-US" sz="1200" kern="1200" dirty="0"/>
        </a:p>
      </dsp:txBody>
      <dsp:txXfrm>
        <a:off x="6493262" y="568276"/>
        <a:ext cx="1206828" cy="1400908"/>
      </dsp:txXfrm>
    </dsp:sp>
    <dsp:sp modelId="{2542ACB0-68E1-4865-A58F-0AD110188BD0}">
      <dsp:nvSpPr>
        <dsp:cNvPr id="0" name=""/>
        <dsp:cNvSpPr/>
      </dsp:nvSpPr>
      <dsp:spPr>
        <a:xfrm>
          <a:off x="7669623" y="195100"/>
          <a:ext cx="411898" cy="319214"/>
        </a:xfrm>
        <a:prstGeom prst="rightArrow">
          <a:avLst>
            <a:gd name="adj1" fmla="val 60000"/>
            <a:gd name="adj2" fmla="val 50000"/>
          </a:avLst>
        </a:prstGeom>
        <a:solidFill>
          <a:schemeClr val="accent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7669623" y="258943"/>
        <a:ext cx="316134" cy="191528"/>
      </dsp:txXfrm>
    </dsp:sp>
    <dsp:sp modelId="{7448241C-0771-4138-AA03-756E37CD861A}">
      <dsp:nvSpPr>
        <dsp:cNvPr id="0" name=""/>
        <dsp:cNvSpPr/>
      </dsp:nvSpPr>
      <dsp:spPr>
        <a:xfrm>
          <a:off x="8252498" y="178685"/>
          <a:ext cx="1281920" cy="52806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/>
            <a:t>Ref</a:t>
          </a:r>
          <a:endParaRPr lang="en-US" sz="1400" kern="1200" dirty="0"/>
        </a:p>
      </dsp:txBody>
      <dsp:txXfrm>
        <a:off x="8252498" y="178685"/>
        <a:ext cx="1281920" cy="352044"/>
      </dsp:txXfrm>
    </dsp:sp>
    <dsp:sp modelId="{62BDA506-A0F1-491E-BB98-887B6AF0AC58}">
      <dsp:nvSpPr>
        <dsp:cNvPr id="0" name=""/>
        <dsp:cNvSpPr/>
      </dsp:nvSpPr>
      <dsp:spPr>
        <a:xfrm>
          <a:off x="8514804" y="530730"/>
          <a:ext cx="1281920" cy="1476000"/>
        </a:xfrm>
        <a:prstGeom prst="roundRect">
          <a:avLst>
            <a:gd name="adj" fmla="val 10000"/>
          </a:avLst>
        </a:prstGeom>
        <a:solidFill>
          <a:schemeClr val="accent2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Generate reference across all samples (</a:t>
          </a:r>
          <a:r>
            <a:rPr lang="en-US" sz="1200" kern="1200" dirty="0" err="1" smtClean="0"/>
            <a:t>ref.fa</a:t>
          </a:r>
          <a:r>
            <a:rPr lang="en-US" sz="1200" kern="1200" dirty="0" smtClean="0"/>
            <a:t>, ref_98.fa)</a:t>
          </a:r>
          <a:endParaRPr lang="en-US" sz="12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Process: 10</a:t>
          </a:r>
          <a:endParaRPr lang="en-US" sz="1200" kern="1200" dirty="0"/>
        </a:p>
      </dsp:txBody>
      <dsp:txXfrm>
        <a:off x="8552350" y="568276"/>
        <a:ext cx="1206828" cy="1400908"/>
      </dsp:txXfrm>
    </dsp:sp>
    <dsp:sp modelId="{DDF1C8D0-62BF-4EB6-8860-51E8F9E74E74}">
      <dsp:nvSpPr>
        <dsp:cNvPr id="0" name=""/>
        <dsp:cNvSpPr/>
      </dsp:nvSpPr>
      <dsp:spPr>
        <a:xfrm>
          <a:off x="9728711" y="195100"/>
          <a:ext cx="411898" cy="319214"/>
        </a:xfrm>
        <a:prstGeom prst="rightArrow">
          <a:avLst>
            <a:gd name="adj1" fmla="val 60000"/>
            <a:gd name="adj2" fmla="val 50000"/>
          </a:avLst>
        </a:prstGeom>
        <a:solidFill>
          <a:schemeClr val="accent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177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400" kern="1200"/>
        </a:p>
      </dsp:txBody>
      <dsp:txXfrm>
        <a:off x="9728711" y="258943"/>
        <a:ext cx="316134" cy="191528"/>
      </dsp:txXfrm>
    </dsp:sp>
    <dsp:sp modelId="{9C21224D-F6F0-4B8F-B141-248FB806DB02}">
      <dsp:nvSpPr>
        <dsp:cNvPr id="0" name=""/>
        <dsp:cNvSpPr/>
      </dsp:nvSpPr>
      <dsp:spPr>
        <a:xfrm>
          <a:off x="10311586" y="178685"/>
          <a:ext cx="1281920" cy="52806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/>
            <a:t>SNP</a:t>
          </a:r>
          <a:endParaRPr lang="en-US" sz="1400" kern="1200" dirty="0"/>
        </a:p>
      </dsp:txBody>
      <dsp:txXfrm>
        <a:off x="10311586" y="178685"/>
        <a:ext cx="1281920" cy="352044"/>
      </dsp:txXfrm>
    </dsp:sp>
    <dsp:sp modelId="{38A7CA3C-6AE6-4798-A503-6779B2997955}">
      <dsp:nvSpPr>
        <dsp:cNvPr id="0" name=""/>
        <dsp:cNvSpPr/>
      </dsp:nvSpPr>
      <dsp:spPr>
        <a:xfrm>
          <a:off x="10573892" y="530730"/>
          <a:ext cx="1281920" cy="1476000"/>
        </a:xfrm>
        <a:prstGeom prst="roundRect">
          <a:avLst>
            <a:gd name="adj" fmla="val 10000"/>
          </a:avLst>
        </a:prstGeom>
        <a:solidFill>
          <a:schemeClr val="accent2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Alignment data and SNP calling (</a:t>
          </a:r>
          <a:r>
            <a:rPr lang="en-US" sz="1200" kern="1200" dirty="0" err="1" smtClean="0"/>
            <a:t>Sample.Gr.sorted.bam</a:t>
          </a:r>
          <a:r>
            <a:rPr lang="en-US" sz="1200" kern="1200" dirty="0" smtClean="0"/>
            <a:t>)</a:t>
          </a:r>
          <a:endParaRPr lang="en-US" sz="12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200" kern="1200" dirty="0" smtClean="0"/>
            <a:t>Process: 11-18</a:t>
          </a:r>
          <a:endParaRPr lang="en-US" sz="1200" kern="1200" dirty="0"/>
        </a:p>
      </dsp:txBody>
      <dsp:txXfrm>
        <a:off x="10611438" y="568276"/>
        <a:ext cx="1206828" cy="140090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3">
  <dgm:title val=""/>
  <dgm:desc val=""/>
  <dgm:catLst>
    <dgm:cat type="process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3" destOrd="0"/>
        <dgm:cxn modelId="12" srcId="1" destId="11" srcOrd="0" destOrd="0"/>
        <dgm:cxn modelId="23" srcId="2" destId="21" srcOrd="0" destOrd="0"/>
        <dgm:cxn modelId="34" srcId="3" destId="31" srcOrd="0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  <dgm:pt modelId="4">
          <dgm:prSet phldr="1"/>
        </dgm:pt>
        <dgm:pt modelId="41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choose name="Name0">
      <dgm:if name="Name1" func="var" arg="dir" op="equ" val="norm">
        <dgm:alg type="lin"/>
      </dgm:if>
      <dgm:else name="Name2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osite" refType="w"/>
      <dgm:constr type="w" for="ch" ptType="sibTrans" refType="w" refFor="ch" refForName="composite" fact="0.3333"/>
      <dgm:constr type="w" for="des" forName="parTx"/>
      <dgm:constr type="h" for="des" forName="parTx" op="equ"/>
      <dgm:constr type="h" for="des" forName="parSh" op="equ"/>
      <dgm:constr type="w" for="des" forName="desTx"/>
      <dgm:constr type="h" for="des" forName="desTx" op="equ"/>
      <dgm:constr type="w" for="des" forName="parSh"/>
      <dgm:constr type="primFontSz" for="des" forName="parTx" val="65"/>
      <dgm:constr type="secFontSz" for="des" forName="desTx" refType="primFontSz" refFor="des" refForName="parTx" op="equ"/>
      <dgm:constr type="primFontSz" for="des" forName="connTx" refType="primFontSz" refFor="des" refForName="parTx" fact="0.8"/>
      <dgm:constr type="primFontSz" for="des" forName="connTx" refType="primFontSz" refFor="des" refForName="parTx" op="lte" fact="0.8"/>
      <dgm:constr type="h" for="des" forName="parTx" refType="primFontSz" refFor="des" refForName="parTx" fact="0.8"/>
      <dgm:constr type="h" for="des" forName="parSh" refType="primFontSz" refFor="des" refForName="parTx" fact="1.2"/>
      <dgm:constr type="h" for="des" forName="desTx" refType="primFontSz" refFor="des" refForName="parTx" fact="1.6"/>
      <dgm:constr type="h" for="des" forName="parSh" refType="h" refFor="des" refForName="parTx" op="lte" fact="1.5"/>
      <dgm:constr type="h" for="des" forName="parSh" refType="h" refFor="des" refForName="parTx" op="gte" fact="1.5"/>
    </dgm:constrLst>
    <dgm:ruleLst>
      <dgm:rule type="w" for="ch" forName="composite" val="0" fact="NaN" max="NaN"/>
      <dgm:rule type="primFontSz" for="des" forName="parTx" val="5" fact="NaN" max="NaN"/>
    </dgm:ruleLst>
    <dgm:forEach name="Name3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4">
          <dgm:if name="Name5" func="var" arg="dir" op="equ" val="norm">
            <dgm:constrLst>
              <dgm:constr type="h" refType="w" fact="1000"/>
              <dgm:constr type="l" for="ch" forName="parTx"/>
              <dgm:constr type="w" for="ch" forName="parTx" refType="w" fact="0.83"/>
              <dgm:constr type="t" for="ch" forName="parTx"/>
              <dgm:constr type="l" for="ch" forName="parSh"/>
              <dgm:constr type="w" for="ch" forName="parSh" refType="w" refFor="ch" refForName="parTx"/>
              <dgm:constr type="t" for="ch" forName="parSh"/>
              <dgm:constr type="l" for="ch" forName="desTx" refType="w" fact="0.17"/>
              <dgm:constr type="w" for="ch" forName="desTx" refType="w" refFor="ch" refForName="parTx"/>
              <dgm:constr type="t" for="ch" forName="desTx" refType="h" refFor="ch" refForName="parTx"/>
            </dgm:constrLst>
          </dgm:if>
          <dgm:else name="Name6">
            <dgm:constrLst>
              <dgm:constr type="h" refType="w" fact="1000"/>
              <dgm:constr type="l" for="ch" forName="parTx" refType="w" fact="0.17"/>
              <dgm:constr type="w" for="ch" forName="parTx" refType="w" fact="0.83"/>
              <dgm:constr type="t" for="ch" forName="parTx"/>
              <dgm:constr type="l" for="ch" forName="parSh" refType="w" fact="0.15"/>
              <dgm:constr type="w" for="ch" forName="parSh" refType="w" refFor="ch" refForName="parTx"/>
              <dgm:constr type="t" for="ch" forName="parSh"/>
              <dgm:constr type="l" for="ch" forName="desTx"/>
              <dgm:constr type="w" for="ch" forName="desTx" refType="w" refFor="ch" refForName="parTx"/>
              <dgm:constr type="t" for="ch" forName="desTx" refType="h" refFor="ch" refForName="parTx"/>
            </dgm:constrLst>
          </dgm:else>
        </dgm:choose>
        <dgm:ruleLst>
          <dgm:rule type="h" val="INF" fact="NaN" max="NaN"/>
        </dgm:ruleLst>
        <dgm:layoutNode name="parTx">
          <dgm:varLst>
            <dgm:chMax val="0"/>
            <dgm:chPref val="0"/>
            <dgm:bulletEnabled val="1"/>
          </dgm:varLst>
          <dgm:alg type="tx">
            <dgm:param type="parTxLTRAlign" val="l"/>
            <dgm:param type="parTxRTLAlign" val="r"/>
            <dgm:param type="txAnchorVert" val="t"/>
          </dgm:alg>
          <dgm:shape xmlns:r="http://schemas.openxmlformats.org/officeDocument/2006/relationships" type="rect" r:blip="" zOrderOff="1" hideGeom="1">
            <dgm:adjLst>
              <dgm:adj idx="1" val="0.1"/>
            </dgm:adjLst>
          </dgm:shape>
          <dgm:presOf axis="self" ptType="node"/>
          <dgm:constrLst>
            <dgm:constr type="h" refType="w" op="lte" fact="0.4"/>
            <dgm:constr type="bMarg" refType="primFontSz" fact="0.3"/>
            <dgm:constr type="h"/>
          </dgm:constrLst>
          <dgm:ruleLst>
            <dgm:rule type="h" val="INF" fact="NaN" max="NaN"/>
          </dgm:ruleLst>
        </dgm:layoutNode>
        <dgm:layoutNode name="parSh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 axis="self" ptType="node"/>
          <dgm:constrLst>
            <dgm:constr type="h"/>
          </dgm:constrLst>
          <dgm:ruleLst/>
        </dgm:layoutNode>
        <dgm:layoutNode name="desTx" styleLbl="fgAcc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oundRect" r:blip="">
            <dgm:adjLst>
              <dgm:adj idx="1" val="0.1"/>
            </dgm:adjLst>
          </dgm:shape>
          <dgm:presOf axis="des" ptType="node"/>
          <dgm:constrLst>
            <dgm:constr type="secFontSz" val="65"/>
            <dgm:constr type="primFontSz" refType="secFontSz"/>
            <dgm:constr type="h"/>
          </dgm:constrLst>
          <dgm:ruleLst>
            <dgm:rule type="h" val="INF" fact="NaN" max="NaN"/>
          </dgm:ruleLst>
        </dgm:layoutNode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  <dgm:param type="srcNode" val="parTx"/>
            <dgm:param type="dstNode" val="parTx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Tx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371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527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997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86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28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465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59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065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397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220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737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6E7A3-AF14-4CF3-ABD8-320289788CCD}" type="datetimeFigureOut">
              <a:rPr lang="en-US" smtClean="0"/>
              <a:t>6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6F6B1-B7B7-41D3-875A-5FD6180D1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485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/>
          <p:nvPr>
            <p:extLst>
              <p:ext uri="{D42A27DB-BD31-4B8C-83A1-F6EECF244321}">
                <p14:modId xmlns:p14="http://schemas.microsoft.com/office/powerpoint/2010/main" val="3314892076"/>
              </p:ext>
            </p:extLst>
          </p:nvPr>
        </p:nvGraphicFramePr>
        <p:xfrm>
          <a:off x="201168" y="1106424"/>
          <a:ext cx="11871960" cy="218541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31520" y="3931920"/>
            <a:ext cx="1068019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: The ‘</a:t>
            </a:r>
            <a:r>
              <a:rPr lang="en-US" dirty="0" err="1" smtClean="0"/>
              <a:t>Bcraw</a:t>
            </a:r>
            <a:r>
              <a:rPr lang="en-US" dirty="0" smtClean="0"/>
              <a:t>’ folder comprises the raw sequencing files for individual samples. After trimming, the trimmed sequence files are placed in the ‘</a:t>
            </a:r>
            <a:r>
              <a:rPr lang="en-US" dirty="0" err="1" smtClean="0"/>
              <a:t>BCpc</a:t>
            </a:r>
            <a:r>
              <a:rPr lang="en-US" dirty="0" smtClean="0"/>
              <a:t>’ folder. Using files in the ‘</a:t>
            </a:r>
            <a:r>
              <a:rPr lang="en-US" dirty="0" err="1" smtClean="0"/>
              <a:t>BCpc</a:t>
            </a:r>
            <a:r>
              <a:rPr lang="en-US" dirty="0" smtClean="0"/>
              <a:t>’ folder as input, all files with equal-length reads are placed in ‘</a:t>
            </a:r>
            <a:r>
              <a:rPr lang="en-US" dirty="0" err="1" smtClean="0"/>
              <a:t>BCfin</a:t>
            </a:r>
            <a:r>
              <a:rPr lang="en-US" dirty="0" smtClean="0"/>
              <a:t>’ folder. The ‘ASU’ folder holds the ASU method results for all files present in the ‘</a:t>
            </a:r>
            <a:r>
              <a:rPr lang="en-US" dirty="0" err="1" smtClean="0"/>
              <a:t>BCfin</a:t>
            </a:r>
            <a:r>
              <a:rPr lang="en-US" dirty="0" smtClean="0"/>
              <a:t>’ folder. The ASU results are used to generate a reference; the filtered reference is placed in the ‘Ref’ folder. The trimmed sequences in the ‘</a:t>
            </a:r>
            <a:r>
              <a:rPr lang="en-US" dirty="0" err="1" smtClean="0"/>
              <a:t>BCpc</a:t>
            </a:r>
            <a:r>
              <a:rPr lang="en-US" dirty="0" smtClean="0"/>
              <a:t>’ folder are aligned (with Bowtie) against the reference files in the ‘Ref’ folder; alignments are used for SNP calling (using GATK); all results are stored in the ‘SNP’ folder.  The ‘Process’ number corresponds to the step number in </a:t>
            </a:r>
            <a:r>
              <a:rPr lang="en-US" dirty="0" smtClean="0"/>
              <a:t>Additional file 1: </a:t>
            </a:r>
            <a:r>
              <a:rPr lang="en-US" dirty="0" smtClean="0"/>
              <a:t>Data S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2884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</TotalTime>
  <Words>243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 Qi</dc:creator>
  <cp:lastModifiedBy>Katrien M. Devos</cp:lastModifiedBy>
  <cp:revision>16</cp:revision>
  <dcterms:created xsi:type="dcterms:W3CDTF">2018-03-22T18:21:16Z</dcterms:created>
  <dcterms:modified xsi:type="dcterms:W3CDTF">2018-06-07T01:53:40Z</dcterms:modified>
</cp:coreProperties>
</file>